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11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2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3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4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5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0" r:id="rId2"/>
    <p:sldId id="296" r:id="rId3"/>
    <p:sldId id="275" r:id="rId4"/>
    <p:sldId id="283" r:id="rId5"/>
    <p:sldId id="286" r:id="rId6"/>
    <p:sldId id="301" r:id="rId7"/>
    <p:sldId id="285" r:id="rId8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8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3048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ocuments\&#36786;&#30740;&#27231;&#27083;\&#23455;&#39443;\&#12480;&#12452;&#12474;\ETF\&#26089;&#26543;&#31995;&#32113;\&#29983;&#29702;&#23455;&#39443;\&#12450;&#12475;&#12488;&#12531;&#25277;&#20986;\&#33258;&#28982;&#32769;&#21270;\190809\190809%20&#12463;&#12525;&#12525;&#12501;&#12451;&#12523;&#21547;&#37327;%20&#27700;&#30000;%20No.2-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esktop\200908%20qRT-PCR%20No.1\200908%20qRT-PCR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esktop\200908%20qRT-PCR%20No.1\200908%20qRT-PCR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esktop\200908%20qRT-PCR%20No.1\200908%20qRT-PCR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esktop\200908%20qRT-PCR%20No.1\200908%20qRT-PCR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esktop\200908%20qRT-PCR%20No.1\200908%20qRT-PCR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esktop\200908%20qRT-PCR%20No.1\200908%20qRT-PCR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ocuments\&#36786;&#30740;&#27231;&#27083;\&#23455;&#39443;\&#12480;&#12452;&#12474;\ETF\&#26089;&#26543;&#31995;&#32113;\&#29983;&#29702;&#23455;&#39443;\&#12450;&#12475;&#12488;&#12531;&#25277;&#20986;\&#33258;&#28982;&#32769;&#21270;\190809\190809%20&#12463;&#12525;&#12525;&#12501;&#12451;&#12523;&#21547;&#37327;%20&#27700;&#30000;%20No.2-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ocuments\&#36786;&#30740;&#27231;&#27083;\&#23455;&#39443;\&#12480;&#12452;&#12474;\ETF\&#26089;&#26543;&#31995;&#32113;\&#29983;&#29702;&#23455;&#39443;\&#12450;&#12475;&#12488;&#12531;&#25277;&#20986;\&#33258;&#28982;&#32769;&#21270;\190809\190809%20&#12463;&#12525;&#12525;&#12501;&#12451;&#12523;&#21547;&#37327;%20&#27700;&#30000;%20No.2-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ocuments\&#36786;&#30740;&#27231;&#27083;\&#23455;&#39443;\&#12480;&#12452;&#12474;\ETF\&#26089;&#26543;&#31995;&#32113;\&#29983;&#29702;&#23455;&#39443;\&#12450;&#12475;&#12488;&#12531;&#25277;&#20986;\&#33258;&#28982;&#32769;&#21270;\190809\190809%20&#12463;&#12525;&#12525;&#12501;&#12451;&#12523;&#21547;&#37327;%20&#27700;&#30000;%20No.2-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&#28009;&#21490;\Documents\&#36786;&#30740;&#27231;&#27083;\&#23455;&#39443;\&#12480;&#12452;&#12474;\ETF\&#26089;&#26543;&#31995;&#32113;\&#29983;&#29702;&#23455;&#39443;\SAPD\&#26263;&#40658;&#20966;&#29702;\200514\200514%20&#26263;&#40658;&#20966;&#29702;&#12288;SPAD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8009;&#21490;\Desktop\200407\2020-04-07%20110801-ViiA7-export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8009;&#21490;\Desktop\200407\2020-04-07%20110801-ViiA7-export.xls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8009;&#21490;\Documents\&#36786;&#30740;&#27231;&#27083;\&#23455;&#39443;\&#12480;&#12452;&#12474;\ETF\&#26089;&#26543;&#31995;&#32113;\RT-PCR\qRT-PCR\&#26263;&#40658;&#20966;&#29702;\200407\2020-05-11%20155958-ViiA7-export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67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67:$P$67</c:f>
                <c:numCache>
                  <c:formatCode>General</c:formatCode>
                  <c:ptCount val="6"/>
                  <c:pt idx="0">
                    <c:v>0.18219676690288023</c:v>
                  </c:pt>
                  <c:pt idx="1">
                    <c:v>0.11162051960528403</c:v>
                  </c:pt>
                  <c:pt idx="2">
                    <c:v>0.15045863531682577</c:v>
                  </c:pt>
                  <c:pt idx="3">
                    <c:v>0.12760717400999047</c:v>
                  </c:pt>
                  <c:pt idx="4">
                    <c:v>0.11385691246188619</c:v>
                  </c:pt>
                  <c:pt idx="5">
                    <c:v>0.16521479116796009</c:v>
                  </c:pt>
                </c:numCache>
              </c:numRef>
            </c:plus>
            <c:minus>
              <c:numRef>
                <c:f>Sheet2!$K$67:$P$67</c:f>
                <c:numCache>
                  <c:formatCode>General</c:formatCode>
                  <c:ptCount val="6"/>
                  <c:pt idx="0">
                    <c:v>0.18219676690288023</c:v>
                  </c:pt>
                  <c:pt idx="1">
                    <c:v>0.11162051960528403</c:v>
                  </c:pt>
                  <c:pt idx="2">
                    <c:v>0.15045863531682577</c:v>
                  </c:pt>
                  <c:pt idx="3">
                    <c:v>0.12760717400999047</c:v>
                  </c:pt>
                  <c:pt idx="4">
                    <c:v>0.11385691246188619</c:v>
                  </c:pt>
                  <c:pt idx="5">
                    <c:v>0.165214791167960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C$66:$H$66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2!$C$67:$H$67</c:f>
              <c:numCache>
                <c:formatCode>General</c:formatCode>
                <c:ptCount val="6"/>
                <c:pt idx="0">
                  <c:v>2.3545091200000003</c:v>
                </c:pt>
                <c:pt idx="1">
                  <c:v>2.5392638400000003</c:v>
                </c:pt>
                <c:pt idx="2">
                  <c:v>3.0126665600000004</c:v>
                </c:pt>
                <c:pt idx="3">
                  <c:v>3.0211136000000005</c:v>
                </c:pt>
                <c:pt idx="4">
                  <c:v>3.3862310399999997</c:v>
                </c:pt>
                <c:pt idx="5">
                  <c:v>2.8759223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5DC-4F71-8AF2-AC952E96E2C1}"/>
            </c:ext>
          </c:extLst>
        </c:ser>
        <c:ser>
          <c:idx val="1"/>
          <c:order val="1"/>
          <c:tx>
            <c:strRef>
              <c:f>Sheet2!$B$68</c:f>
              <c:strCache>
                <c:ptCount val="1"/>
                <c:pt idx="0">
                  <c:v>els1-2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68:$P$68</c:f>
                <c:numCache>
                  <c:formatCode>General</c:formatCode>
                  <c:ptCount val="6"/>
                  <c:pt idx="0">
                    <c:v>7.2402990486039973E-2</c:v>
                  </c:pt>
                  <c:pt idx="1">
                    <c:v>8.0797680517044543E-2</c:v>
                  </c:pt>
                  <c:pt idx="2">
                    <c:v>4.7510224134247152E-2</c:v>
                  </c:pt>
                  <c:pt idx="3">
                    <c:v>2.7485626340587592E-2</c:v>
                  </c:pt>
                  <c:pt idx="4">
                    <c:v>8.6437482373331431E-2</c:v>
                  </c:pt>
                  <c:pt idx="5">
                    <c:v>2.6065168851369436E-2</c:v>
                  </c:pt>
                </c:numCache>
              </c:numRef>
            </c:plus>
            <c:minus>
              <c:numRef>
                <c:f>Sheet2!$K$68:$P$68</c:f>
                <c:numCache>
                  <c:formatCode>General</c:formatCode>
                  <c:ptCount val="6"/>
                  <c:pt idx="0">
                    <c:v>7.2402990486039973E-2</c:v>
                  </c:pt>
                  <c:pt idx="1">
                    <c:v>8.0797680517044543E-2</c:v>
                  </c:pt>
                  <c:pt idx="2">
                    <c:v>4.7510224134247152E-2</c:v>
                  </c:pt>
                  <c:pt idx="3">
                    <c:v>2.7485626340587592E-2</c:v>
                  </c:pt>
                  <c:pt idx="4">
                    <c:v>8.6437482373331431E-2</c:v>
                  </c:pt>
                  <c:pt idx="5">
                    <c:v>2.606516885136943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C$66:$H$66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2!$C$68:$H$68</c:f>
              <c:numCache>
                <c:formatCode>General</c:formatCode>
                <c:ptCount val="6"/>
                <c:pt idx="0">
                  <c:v>1.5657377600000002</c:v>
                </c:pt>
                <c:pt idx="1">
                  <c:v>1.7678754400000003</c:v>
                </c:pt>
                <c:pt idx="2">
                  <c:v>1.7294825599999999</c:v>
                </c:pt>
                <c:pt idx="3">
                  <c:v>1.13507472</c:v>
                </c:pt>
                <c:pt idx="4">
                  <c:v>0.88219840000000005</c:v>
                </c:pt>
                <c:pt idx="5">
                  <c:v>0.11694408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5DC-4F71-8AF2-AC952E96E2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5215184"/>
        <c:axId val="1785216272"/>
      </c:scatterChart>
      <c:valAx>
        <c:axId val="1785215184"/>
        <c:scaling>
          <c:orientation val="minMax"/>
          <c:max val="5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85216272"/>
        <c:crosses val="autoZero"/>
        <c:crossBetween val="midCat"/>
        <c:majorUnit val="1"/>
      </c:valAx>
      <c:valAx>
        <c:axId val="1785216272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85215184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F3F-4768-B10F-1D66A4EF78F1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F3F-4768-B10F-1D66A4EF78F1}"/>
              </c:ext>
            </c:extLst>
          </c:dPt>
          <c:errBars>
            <c:errBarType val="plus"/>
            <c:errValType val="cust"/>
            <c:noEndCap val="0"/>
            <c:plus>
              <c:numRef>
                <c:f>'PsaL 21'!$G$5:$G$6</c:f>
                <c:numCache>
                  <c:formatCode>General</c:formatCode>
                  <c:ptCount val="2"/>
                  <c:pt idx="0">
                    <c:v>0.17892796232527722</c:v>
                  </c:pt>
                  <c:pt idx="1">
                    <c:v>0.12054651352312853</c:v>
                  </c:pt>
                </c:numCache>
              </c:numRef>
            </c:plus>
            <c:minus>
              <c:numRef>
                <c:f>'PsaL 21'!$G$5:$G$6</c:f>
                <c:numCache>
                  <c:formatCode>General</c:formatCode>
                  <c:ptCount val="2"/>
                  <c:pt idx="0">
                    <c:v>0.17892796232527722</c:v>
                  </c:pt>
                  <c:pt idx="1">
                    <c:v>0.120546513523128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saL 21'!$F$2:$F$3</c:f>
              <c:strCache>
                <c:ptCount val="2"/>
                <c:pt idx="0">
                  <c:v>WT</c:v>
                </c:pt>
                <c:pt idx="1">
                  <c:v>els1-2</c:v>
                </c:pt>
              </c:strCache>
            </c:strRef>
          </c:cat>
          <c:val>
            <c:numRef>
              <c:f>'PsaL 21'!$G$2:$G$3</c:f>
              <c:numCache>
                <c:formatCode>General</c:formatCode>
                <c:ptCount val="2"/>
                <c:pt idx="0">
                  <c:v>0.99981304090411027</c:v>
                </c:pt>
                <c:pt idx="1">
                  <c:v>1.46355196068134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F3F-4768-B10F-1D66A4EF78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3622176"/>
        <c:axId val="1833618912"/>
      </c:barChart>
      <c:catAx>
        <c:axId val="18336221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33618912"/>
        <c:crosses val="autoZero"/>
        <c:auto val="1"/>
        <c:lblAlgn val="ctr"/>
        <c:lblOffset val="100"/>
        <c:noMultiLvlLbl val="0"/>
      </c:catAx>
      <c:valAx>
        <c:axId val="1833618912"/>
        <c:scaling>
          <c:orientation val="minMax"/>
          <c:max val="2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3622176"/>
        <c:crosses val="autoZero"/>
        <c:crossBetween val="between"/>
        <c:majorUnit val="0.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2CD-4EBC-856D-9ACDB7D1B18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2CD-4EBC-856D-9ACDB7D1B18D}"/>
              </c:ext>
            </c:extLst>
          </c:dPt>
          <c:errBars>
            <c:errBarType val="plus"/>
            <c:errValType val="cust"/>
            <c:noEndCap val="0"/>
            <c:plus>
              <c:numRef>
                <c:f>'PsaH 11'!$G$5:$G$6</c:f>
                <c:numCache>
                  <c:formatCode>General</c:formatCode>
                  <c:ptCount val="2"/>
                  <c:pt idx="0">
                    <c:v>0.18564884071087145</c:v>
                  </c:pt>
                  <c:pt idx="1">
                    <c:v>9.2865615590224451E-2</c:v>
                  </c:pt>
                </c:numCache>
              </c:numRef>
            </c:plus>
            <c:minus>
              <c:numRef>
                <c:f>'PsaH 11'!$G$5:$G$6</c:f>
                <c:numCache>
                  <c:formatCode>General</c:formatCode>
                  <c:ptCount val="2"/>
                  <c:pt idx="0">
                    <c:v>0.18564884071087145</c:v>
                  </c:pt>
                  <c:pt idx="1">
                    <c:v>9.286561559022445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saH 11'!$F$2:$F$3</c:f>
              <c:strCache>
                <c:ptCount val="2"/>
                <c:pt idx="0">
                  <c:v>WT</c:v>
                </c:pt>
                <c:pt idx="1">
                  <c:v>els1-2</c:v>
                </c:pt>
              </c:strCache>
            </c:strRef>
          </c:cat>
          <c:val>
            <c:numRef>
              <c:f>'PsaH 11'!$G$2:$G$3</c:f>
              <c:numCache>
                <c:formatCode>General</c:formatCode>
                <c:ptCount val="2"/>
                <c:pt idx="0">
                  <c:v>1.0001638610289334</c:v>
                </c:pt>
                <c:pt idx="1">
                  <c:v>1.42039755554274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2CD-4EBC-856D-9ACDB7D1B1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3620544"/>
        <c:axId val="1833615648"/>
      </c:barChart>
      <c:catAx>
        <c:axId val="18336205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33615648"/>
        <c:crosses val="autoZero"/>
        <c:auto val="1"/>
        <c:lblAlgn val="ctr"/>
        <c:lblOffset val="100"/>
        <c:noMultiLvlLbl val="0"/>
      </c:catAx>
      <c:valAx>
        <c:axId val="1833615648"/>
        <c:scaling>
          <c:orientation val="minMax"/>
          <c:max val="2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3620544"/>
        <c:crosses val="autoZero"/>
        <c:crossBetween val="between"/>
        <c:majorUnit val="0.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597-4EAA-B65E-94F395B0AD1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597-4EAA-B65E-94F395B0AD10}"/>
              </c:ext>
            </c:extLst>
          </c:dPt>
          <c:errBars>
            <c:errBarType val="plus"/>
            <c:errValType val="cust"/>
            <c:noEndCap val="0"/>
            <c:plus>
              <c:numRef>
                <c:f>'Lhca2 11'!$G$5:$G$6</c:f>
                <c:numCache>
                  <c:formatCode>General</c:formatCode>
                  <c:ptCount val="2"/>
                  <c:pt idx="0">
                    <c:v>0.14812340595291487</c:v>
                  </c:pt>
                  <c:pt idx="1">
                    <c:v>0.13635017974959299</c:v>
                  </c:pt>
                </c:numCache>
              </c:numRef>
            </c:plus>
            <c:minus>
              <c:numRef>
                <c:f>'Lhca2 11'!$G$5:$G$6</c:f>
                <c:numCache>
                  <c:formatCode>General</c:formatCode>
                  <c:ptCount val="2"/>
                  <c:pt idx="0">
                    <c:v>0.14812340595291487</c:v>
                  </c:pt>
                  <c:pt idx="1">
                    <c:v>0.136350179749592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hca2 11'!$F$2:$F$3</c:f>
              <c:strCache>
                <c:ptCount val="2"/>
                <c:pt idx="0">
                  <c:v>WT</c:v>
                </c:pt>
                <c:pt idx="1">
                  <c:v>els1-2</c:v>
                </c:pt>
              </c:strCache>
            </c:strRef>
          </c:cat>
          <c:val>
            <c:numRef>
              <c:f>'Lhca2 11'!$G$2:$G$3</c:f>
              <c:numCache>
                <c:formatCode>General</c:formatCode>
                <c:ptCount val="2"/>
                <c:pt idx="0">
                  <c:v>1.0001945709521061</c:v>
                </c:pt>
                <c:pt idx="1">
                  <c:v>1.31900184993128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597-4EAA-B65E-94F395B0AD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0098240"/>
        <c:axId val="1870097152"/>
      </c:barChart>
      <c:catAx>
        <c:axId val="18700982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70097152"/>
        <c:crosses val="autoZero"/>
        <c:auto val="1"/>
        <c:lblAlgn val="ctr"/>
        <c:lblOffset val="100"/>
        <c:noMultiLvlLbl val="0"/>
      </c:catAx>
      <c:valAx>
        <c:axId val="1870097152"/>
        <c:scaling>
          <c:orientation val="minMax"/>
          <c:max val="2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70098240"/>
        <c:crosses val="autoZero"/>
        <c:crossBetween val="between"/>
        <c:majorUnit val="0.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0D1-465D-B7A5-1CB9840401F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0D1-465D-B7A5-1CB9840401F8}"/>
              </c:ext>
            </c:extLst>
          </c:dPt>
          <c:errBars>
            <c:errBarType val="plus"/>
            <c:errValType val="cust"/>
            <c:noEndCap val="0"/>
            <c:plus>
              <c:numRef>
                <c:f>'Lhca1 11'!$G$5:$G$6</c:f>
                <c:numCache>
                  <c:formatCode>General</c:formatCode>
                  <c:ptCount val="2"/>
                  <c:pt idx="0">
                    <c:v>0.22689731993055784</c:v>
                  </c:pt>
                  <c:pt idx="1">
                    <c:v>0.16181674795073725</c:v>
                  </c:pt>
                </c:numCache>
              </c:numRef>
            </c:plus>
            <c:minus>
              <c:numRef>
                <c:f>'Lhca1 11'!$G$5:$G$6</c:f>
                <c:numCache>
                  <c:formatCode>General</c:formatCode>
                  <c:ptCount val="2"/>
                  <c:pt idx="0">
                    <c:v>0.22689731993055784</c:v>
                  </c:pt>
                  <c:pt idx="1">
                    <c:v>0.161816747950737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hca1 11'!$F$2:$F$3</c:f>
              <c:strCache>
                <c:ptCount val="2"/>
                <c:pt idx="0">
                  <c:v>WT</c:v>
                </c:pt>
                <c:pt idx="1">
                  <c:v>els1-2</c:v>
                </c:pt>
              </c:strCache>
            </c:strRef>
          </c:cat>
          <c:val>
            <c:numRef>
              <c:f>'Lhca1 11'!$G$2:$G$3</c:f>
              <c:numCache>
                <c:formatCode>General</c:formatCode>
                <c:ptCount val="2"/>
                <c:pt idx="0">
                  <c:v>0.99982530323427099</c:v>
                </c:pt>
                <c:pt idx="1">
                  <c:v>1.47779966468241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0D1-465D-B7A5-1CB9840401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0094432"/>
        <c:axId val="1870101504"/>
      </c:barChart>
      <c:catAx>
        <c:axId val="18700944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70101504"/>
        <c:crosses val="autoZero"/>
        <c:auto val="1"/>
        <c:lblAlgn val="ctr"/>
        <c:lblOffset val="100"/>
        <c:noMultiLvlLbl val="0"/>
      </c:catAx>
      <c:valAx>
        <c:axId val="1870101504"/>
        <c:scaling>
          <c:orientation val="minMax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70094432"/>
        <c:crosses val="autoZero"/>
        <c:crossBetween val="between"/>
        <c:majorUnit val="0.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E9D-4290-BB11-C3CD77685FF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9D-4290-BB11-C3CD77685FF3}"/>
              </c:ext>
            </c:extLst>
          </c:dPt>
          <c:errBars>
            <c:errBarType val="plus"/>
            <c:errValType val="cust"/>
            <c:noEndCap val="0"/>
            <c:plus>
              <c:numRef>
                <c:f>'Lhcb1 11'!$G$5:$G$6</c:f>
                <c:numCache>
                  <c:formatCode>General</c:formatCode>
                  <c:ptCount val="2"/>
                  <c:pt idx="0">
                    <c:v>0.16581228644040183</c:v>
                  </c:pt>
                  <c:pt idx="1">
                    <c:v>0.14249773667781443</c:v>
                  </c:pt>
                </c:numCache>
              </c:numRef>
            </c:plus>
            <c:minus>
              <c:numRef>
                <c:f>'Lhcb1 11'!$G$5:$G$6</c:f>
                <c:numCache>
                  <c:formatCode>General</c:formatCode>
                  <c:ptCount val="2"/>
                  <c:pt idx="0">
                    <c:v>0.16581228644040183</c:v>
                  </c:pt>
                  <c:pt idx="1">
                    <c:v>0.142497736677814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hcb1 11'!$F$2:$F$3</c:f>
              <c:strCache>
                <c:ptCount val="2"/>
                <c:pt idx="0">
                  <c:v>WT</c:v>
                </c:pt>
                <c:pt idx="1">
                  <c:v>els1-2</c:v>
                </c:pt>
              </c:strCache>
            </c:strRef>
          </c:cat>
          <c:val>
            <c:numRef>
              <c:f>'Lhcb1 11'!$G$2:$G$3</c:f>
              <c:numCache>
                <c:formatCode>General</c:formatCode>
                <c:ptCount val="2"/>
                <c:pt idx="0">
                  <c:v>1.0001842945689439</c:v>
                </c:pt>
                <c:pt idx="1">
                  <c:v>1.4292904688889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E9D-4290-BB11-C3CD77685F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0100416"/>
        <c:axId val="1870094976"/>
      </c:barChart>
      <c:catAx>
        <c:axId val="18701004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70094976"/>
        <c:crosses val="autoZero"/>
        <c:auto val="1"/>
        <c:lblAlgn val="ctr"/>
        <c:lblOffset val="100"/>
        <c:noMultiLvlLbl val="0"/>
      </c:catAx>
      <c:valAx>
        <c:axId val="1870094976"/>
        <c:scaling>
          <c:orientation val="minMax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70100416"/>
        <c:crosses val="autoZero"/>
        <c:crossBetween val="between"/>
        <c:majorUnit val="0.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1CD-4581-A4D8-C6888176E0C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1CD-4581-A4D8-C6888176E0C4}"/>
              </c:ext>
            </c:extLst>
          </c:dPt>
          <c:errBars>
            <c:errBarType val="plus"/>
            <c:errValType val="cust"/>
            <c:noEndCap val="0"/>
            <c:plus>
              <c:numRef>
                <c:f>'200911 Lhcb2 11'!$G$5:$G$6</c:f>
                <c:numCache>
                  <c:formatCode>General</c:formatCode>
                  <c:ptCount val="2"/>
                  <c:pt idx="0">
                    <c:v>0.18674810175908374</c:v>
                  </c:pt>
                  <c:pt idx="1">
                    <c:v>0.11523402836022786</c:v>
                  </c:pt>
                </c:numCache>
              </c:numRef>
            </c:plus>
            <c:minus>
              <c:numRef>
                <c:f>'200911 Lhcb2 11'!$G$5:$G$6</c:f>
                <c:numCache>
                  <c:formatCode>General</c:formatCode>
                  <c:ptCount val="2"/>
                  <c:pt idx="0">
                    <c:v>0.18674810175908374</c:v>
                  </c:pt>
                  <c:pt idx="1">
                    <c:v>0.115234028360227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00911 Lhcb2 11'!$F$2:$F$3</c:f>
              <c:strCache>
                <c:ptCount val="2"/>
                <c:pt idx="0">
                  <c:v>WT</c:v>
                </c:pt>
                <c:pt idx="1">
                  <c:v>els1-2</c:v>
                </c:pt>
              </c:strCache>
            </c:strRef>
          </c:cat>
          <c:val>
            <c:numRef>
              <c:f>'200911 Lhcb2 11'!$G$2:$G$3</c:f>
              <c:numCache>
                <c:formatCode>General</c:formatCode>
                <c:ptCount val="2"/>
                <c:pt idx="0">
                  <c:v>0.99987017509532827</c:v>
                </c:pt>
                <c:pt idx="1">
                  <c:v>1.47038497423749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1CD-4581-A4D8-C6888176E0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70100960"/>
        <c:axId val="1870095520"/>
      </c:barChart>
      <c:catAx>
        <c:axId val="187010096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70095520"/>
        <c:crosses val="autoZero"/>
        <c:auto val="1"/>
        <c:lblAlgn val="ctr"/>
        <c:lblOffset val="100"/>
        <c:noMultiLvlLbl val="0"/>
      </c:catAx>
      <c:valAx>
        <c:axId val="1870095520"/>
        <c:scaling>
          <c:orientation val="minMax"/>
          <c:min val="0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70100960"/>
        <c:crosses val="autoZero"/>
        <c:crossBetween val="between"/>
        <c:majorUnit val="0.5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73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73:$P$73</c:f>
                <c:numCache>
                  <c:formatCode>General</c:formatCode>
                  <c:ptCount val="6"/>
                  <c:pt idx="0">
                    <c:v>4.4644427437422612E-2</c:v>
                  </c:pt>
                  <c:pt idx="1">
                    <c:v>3.3082736983599849E-2</c:v>
                  </c:pt>
                  <c:pt idx="2">
                    <c:v>4.7252139752194E-2</c:v>
                  </c:pt>
                  <c:pt idx="3">
                    <c:v>5.499387883170679E-2</c:v>
                  </c:pt>
                  <c:pt idx="4">
                    <c:v>3.4262733030084536E-2</c:v>
                  </c:pt>
                  <c:pt idx="5">
                    <c:v>4.8258305996287193E-2</c:v>
                  </c:pt>
                </c:numCache>
              </c:numRef>
            </c:plus>
            <c:minus>
              <c:numRef>
                <c:f>Sheet2!$K$73:$P$73</c:f>
                <c:numCache>
                  <c:formatCode>General</c:formatCode>
                  <c:ptCount val="6"/>
                  <c:pt idx="0">
                    <c:v>4.4644427437422612E-2</c:v>
                  </c:pt>
                  <c:pt idx="1">
                    <c:v>3.3082736983599849E-2</c:v>
                  </c:pt>
                  <c:pt idx="2">
                    <c:v>4.7252139752194E-2</c:v>
                  </c:pt>
                  <c:pt idx="3">
                    <c:v>5.499387883170679E-2</c:v>
                  </c:pt>
                  <c:pt idx="4">
                    <c:v>3.4262733030084536E-2</c:v>
                  </c:pt>
                  <c:pt idx="5">
                    <c:v>4.82583059962871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C$66:$H$66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2!$C$73:$H$73</c:f>
              <c:numCache>
                <c:formatCode>General</c:formatCode>
                <c:ptCount val="6"/>
                <c:pt idx="0">
                  <c:v>0.5805264533333333</c:v>
                </c:pt>
                <c:pt idx="1">
                  <c:v>0.63801536000000003</c:v>
                </c:pt>
                <c:pt idx="2">
                  <c:v>0.76000426666666676</c:v>
                </c:pt>
                <c:pt idx="3">
                  <c:v>0.76000426666666676</c:v>
                </c:pt>
                <c:pt idx="4">
                  <c:v>0.95605072000000013</c:v>
                </c:pt>
                <c:pt idx="5">
                  <c:v>0.853414879999999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0EE-48AB-85C4-65B908CECC77}"/>
            </c:ext>
          </c:extLst>
        </c:ser>
        <c:ser>
          <c:idx val="1"/>
          <c:order val="1"/>
          <c:tx>
            <c:strRef>
              <c:f>Sheet2!$B$74</c:f>
              <c:strCache>
                <c:ptCount val="1"/>
                <c:pt idx="0">
                  <c:v>els1-2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74:$P$74</c:f>
                <c:numCache>
                  <c:formatCode>General</c:formatCode>
                  <c:ptCount val="6"/>
                  <c:pt idx="0">
                    <c:v>1.5854057913892779E-2</c:v>
                  </c:pt>
                  <c:pt idx="1">
                    <c:v>1.8889523969278652E-2</c:v>
                  </c:pt>
                  <c:pt idx="2">
                    <c:v>1.417028858384096E-2</c:v>
                  </c:pt>
                  <c:pt idx="3">
                    <c:v>1.1810913619635434E-2</c:v>
                  </c:pt>
                  <c:pt idx="4">
                    <c:v>1.4258541524393129E-2</c:v>
                  </c:pt>
                  <c:pt idx="5">
                    <c:v>7.1244057144438178E-3</c:v>
                  </c:pt>
                </c:numCache>
              </c:numRef>
            </c:plus>
            <c:minus>
              <c:numRef>
                <c:f>Sheet2!$K$74:$P$74</c:f>
                <c:numCache>
                  <c:formatCode>General</c:formatCode>
                  <c:ptCount val="6"/>
                  <c:pt idx="0">
                    <c:v>1.5854057913892779E-2</c:v>
                  </c:pt>
                  <c:pt idx="1">
                    <c:v>1.8889523969278652E-2</c:v>
                  </c:pt>
                  <c:pt idx="2">
                    <c:v>1.417028858384096E-2</c:v>
                  </c:pt>
                  <c:pt idx="3">
                    <c:v>1.1810913619635434E-2</c:v>
                  </c:pt>
                  <c:pt idx="4">
                    <c:v>1.4258541524393129E-2</c:v>
                  </c:pt>
                  <c:pt idx="5">
                    <c:v>7.124405714443817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C$66:$H$66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2!$C$74:$H$74</c:f>
              <c:numCache>
                <c:formatCode>General</c:formatCode>
                <c:ptCount val="6"/>
                <c:pt idx="0">
                  <c:v>0.32737274666666666</c:v>
                </c:pt>
                <c:pt idx="1">
                  <c:v>0.37000208000000007</c:v>
                </c:pt>
                <c:pt idx="2">
                  <c:v>0.29584693333333334</c:v>
                </c:pt>
                <c:pt idx="3">
                  <c:v>0.16093023999999997</c:v>
                </c:pt>
                <c:pt idx="4">
                  <c:v>0.13672261333333335</c:v>
                </c:pt>
                <c:pt idx="5">
                  <c:v>6.541479999999999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EE-48AB-85C4-65B908CECC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5215728"/>
        <c:axId val="1785216816"/>
      </c:scatterChart>
      <c:valAx>
        <c:axId val="1785215728"/>
        <c:scaling>
          <c:orientation val="minMax"/>
          <c:max val="5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85216816"/>
        <c:crosses val="autoZero"/>
        <c:crossBetween val="midCat"/>
        <c:majorUnit val="1"/>
      </c:valAx>
      <c:valAx>
        <c:axId val="1785216816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85215728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78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78:$P$78</c:f>
                <c:numCache>
                  <c:formatCode>General</c:formatCode>
                  <c:ptCount val="6"/>
                  <c:pt idx="0">
                    <c:v>1.8056843017087792E-2</c:v>
                  </c:pt>
                  <c:pt idx="1">
                    <c:v>5.5072799839345085E-2</c:v>
                  </c:pt>
                  <c:pt idx="2">
                    <c:v>4.9578026873254445E-2</c:v>
                  </c:pt>
                  <c:pt idx="3">
                    <c:v>4.9578026873254445E-2</c:v>
                  </c:pt>
                  <c:pt idx="4">
                    <c:v>6.5237751598006502E-2</c:v>
                  </c:pt>
                  <c:pt idx="5">
                    <c:v>3.1890322215273541E-2</c:v>
                  </c:pt>
                </c:numCache>
              </c:numRef>
            </c:plus>
            <c:minus>
              <c:numRef>
                <c:f>Sheet2!$K$78:$P$78</c:f>
                <c:numCache>
                  <c:formatCode>General</c:formatCode>
                  <c:ptCount val="6"/>
                  <c:pt idx="0">
                    <c:v>1.8056843017087792E-2</c:v>
                  </c:pt>
                  <c:pt idx="1">
                    <c:v>5.5072799839345085E-2</c:v>
                  </c:pt>
                  <c:pt idx="2">
                    <c:v>4.9578026873254445E-2</c:v>
                  </c:pt>
                  <c:pt idx="3">
                    <c:v>4.9578026873254445E-2</c:v>
                  </c:pt>
                  <c:pt idx="4">
                    <c:v>6.5237751598006502E-2</c:v>
                  </c:pt>
                  <c:pt idx="5">
                    <c:v>3.189032221527354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C$77:$H$77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2!$C$78:$H$78</c:f>
              <c:numCache>
                <c:formatCode>General</c:formatCode>
                <c:ptCount val="6"/>
                <c:pt idx="0">
                  <c:v>4.0559585089204386</c:v>
                </c:pt>
                <c:pt idx="1">
                  <c:v>3.9882698540993493</c:v>
                </c:pt>
                <c:pt idx="2">
                  <c:v>3.9760709516853425</c:v>
                </c:pt>
                <c:pt idx="3">
                  <c:v>3.7869669023484129</c:v>
                </c:pt>
                <c:pt idx="4">
                  <c:v>3.3697394154448519</c:v>
                </c:pt>
                <c:pt idx="5">
                  <c:v>3.36973941544485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D9C-4BEB-8B42-E3159DAB794E}"/>
            </c:ext>
          </c:extLst>
        </c:ser>
        <c:ser>
          <c:idx val="1"/>
          <c:order val="1"/>
          <c:tx>
            <c:strRef>
              <c:f>Sheet2!$B$79</c:f>
              <c:strCache>
                <c:ptCount val="1"/>
                <c:pt idx="0">
                  <c:v>els1-2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79:$P$79</c:f>
                <c:numCache>
                  <c:formatCode>General</c:formatCode>
                  <c:ptCount val="6"/>
                  <c:pt idx="0">
                    <c:v>6.4882550893101631E-2</c:v>
                  </c:pt>
                  <c:pt idx="1">
                    <c:v>6.3307440550375724E-2</c:v>
                  </c:pt>
                  <c:pt idx="2">
                    <c:v>0.18282620966918484</c:v>
                  </c:pt>
                  <c:pt idx="3">
                    <c:v>0.41568019291789815</c:v>
                  </c:pt>
                  <c:pt idx="4">
                    <c:v>0.63315820573711179</c:v>
                  </c:pt>
                  <c:pt idx="5">
                    <c:v>0.34984553412169206</c:v>
                  </c:pt>
                </c:numCache>
              </c:numRef>
            </c:plus>
            <c:minus>
              <c:numRef>
                <c:f>Sheet2!$K$79:$P$79</c:f>
                <c:numCache>
                  <c:formatCode>General</c:formatCode>
                  <c:ptCount val="6"/>
                  <c:pt idx="0">
                    <c:v>6.4882550893101631E-2</c:v>
                  </c:pt>
                  <c:pt idx="1">
                    <c:v>6.3307440550375724E-2</c:v>
                  </c:pt>
                  <c:pt idx="2">
                    <c:v>0.18282620966918484</c:v>
                  </c:pt>
                  <c:pt idx="3">
                    <c:v>0.41568019291789815</c:v>
                  </c:pt>
                  <c:pt idx="4">
                    <c:v>0.63315820573711179</c:v>
                  </c:pt>
                  <c:pt idx="5">
                    <c:v>0.349845534121692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C$77:$H$77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2!$C$79:$H$79</c:f>
              <c:numCache>
                <c:formatCode>General</c:formatCode>
                <c:ptCount val="6"/>
                <c:pt idx="0">
                  <c:v>4.787096743802989</c:v>
                </c:pt>
                <c:pt idx="1">
                  <c:v>4.9468980624172065</c:v>
                </c:pt>
                <c:pt idx="2">
                  <c:v>5.5913384011343465</c:v>
                </c:pt>
                <c:pt idx="3">
                  <c:v>7.1697203136291421</c:v>
                </c:pt>
                <c:pt idx="4">
                  <c:v>6.6138211142239767</c:v>
                </c:pt>
                <c:pt idx="5">
                  <c:v>1.77055737405761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D9C-4BEB-8B42-E3159DAB79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85217360"/>
        <c:axId val="1785217904"/>
      </c:scatterChart>
      <c:valAx>
        <c:axId val="1785217360"/>
        <c:scaling>
          <c:orientation val="minMax"/>
          <c:max val="5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85217904"/>
        <c:crosses val="autoZero"/>
        <c:crossBetween val="midCat"/>
        <c:majorUnit val="1"/>
      </c:valAx>
      <c:valAx>
        <c:axId val="1785217904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85217360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83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83:$P$83</c:f>
                <c:numCache>
                  <c:formatCode>General</c:formatCode>
                  <c:ptCount val="6"/>
                  <c:pt idx="0">
                    <c:v>0.22678494324674997</c:v>
                  </c:pt>
                  <c:pt idx="1">
                    <c:v>0.14408447417442008</c:v>
                  </c:pt>
                  <c:pt idx="2">
                    <c:v>0.19766131750383292</c:v>
                  </c:pt>
                  <c:pt idx="3">
                    <c:v>0.19766131750383292</c:v>
                  </c:pt>
                  <c:pt idx="4">
                    <c:v>0.14491323192045899</c:v>
                  </c:pt>
                  <c:pt idx="5">
                    <c:v>0.21303386084655407</c:v>
                  </c:pt>
                </c:numCache>
              </c:numRef>
            </c:plus>
            <c:minus>
              <c:numRef>
                <c:f>Sheet2!$K$83:$P$83</c:f>
                <c:numCache>
                  <c:formatCode>General</c:formatCode>
                  <c:ptCount val="6"/>
                  <c:pt idx="0">
                    <c:v>0.22678494324674997</c:v>
                  </c:pt>
                  <c:pt idx="1">
                    <c:v>0.14408447417442008</c:v>
                  </c:pt>
                  <c:pt idx="2">
                    <c:v>0.19766131750383292</c:v>
                  </c:pt>
                  <c:pt idx="3">
                    <c:v>0.19766131750383292</c:v>
                  </c:pt>
                  <c:pt idx="4">
                    <c:v>0.14491323192045899</c:v>
                  </c:pt>
                  <c:pt idx="5">
                    <c:v>0.213033860846554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C$77:$H$77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2!$C$83:$H$83</c:f>
              <c:numCache>
                <c:formatCode>General</c:formatCode>
                <c:ptCount val="6"/>
                <c:pt idx="0">
                  <c:v>2.9350355733333338</c:v>
                </c:pt>
                <c:pt idx="1">
                  <c:v>3.1772792000000001</c:v>
                </c:pt>
                <c:pt idx="2">
                  <c:v>3.7726708266666678</c:v>
                </c:pt>
                <c:pt idx="3">
                  <c:v>3.8249546666666667</c:v>
                </c:pt>
                <c:pt idx="4">
                  <c:v>4.3422817600000005</c:v>
                </c:pt>
                <c:pt idx="5">
                  <c:v>3.72933728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E7E-47FA-8783-4573F635C9EA}"/>
            </c:ext>
          </c:extLst>
        </c:ser>
        <c:ser>
          <c:idx val="1"/>
          <c:order val="1"/>
          <c:tx>
            <c:strRef>
              <c:f>Sheet2!$B$84</c:f>
              <c:strCache>
                <c:ptCount val="1"/>
                <c:pt idx="0">
                  <c:v>els1-2</c:v>
                </c:pt>
              </c:strCache>
            </c:strRef>
          </c:tx>
          <c:spPr>
            <a:ln w="19050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K$84:$P$84</c:f>
                <c:numCache>
                  <c:formatCode>General</c:formatCode>
                  <c:ptCount val="6"/>
                  <c:pt idx="0">
                    <c:v>8.7745233379758356E-2</c:v>
                  </c:pt>
                  <c:pt idx="1">
                    <c:v>9.9227182532300548E-2</c:v>
                  </c:pt>
                  <c:pt idx="2">
                    <c:v>0.12196829924054506</c:v>
                  </c:pt>
                  <c:pt idx="3">
                    <c:v>5.8371077520255971E-2</c:v>
                  </c:pt>
                  <c:pt idx="4">
                    <c:v>9.6003037401852662E-2</c:v>
                  </c:pt>
                  <c:pt idx="5">
                    <c:v>3.0160077574475825E-2</c:v>
                  </c:pt>
                </c:numCache>
              </c:numRef>
            </c:plus>
            <c:minus>
              <c:numRef>
                <c:f>Sheet2!$K$84:$P$84</c:f>
                <c:numCache>
                  <c:formatCode>General</c:formatCode>
                  <c:ptCount val="6"/>
                  <c:pt idx="0">
                    <c:v>8.7745233379758356E-2</c:v>
                  </c:pt>
                  <c:pt idx="1">
                    <c:v>9.9227182532300548E-2</c:v>
                  </c:pt>
                  <c:pt idx="2">
                    <c:v>0.12196829924054506</c:v>
                  </c:pt>
                  <c:pt idx="3">
                    <c:v>5.8371077520255971E-2</c:v>
                  </c:pt>
                  <c:pt idx="4">
                    <c:v>9.6003037401852662E-2</c:v>
                  </c:pt>
                  <c:pt idx="5">
                    <c:v>3.016007757447582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C$77:$H$77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xVal>
          <c:yVal>
            <c:numRef>
              <c:f>Sheet2!$C$84:$H$84</c:f>
              <c:numCache>
                <c:formatCode>General</c:formatCode>
                <c:ptCount val="6"/>
                <c:pt idx="0">
                  <c:v>1.8931105066666667</c:v>
                </c:pt>
                <c:pt idx="1">
                  <c:v>2.1973817600000003</c:v>
                </c:pt>
                <c:pt idx="2">
                  <c:v>1.9421904533333332</c:v>
                </c:pt>
                <c:pt idx="3">
                  <c:v>1.2960049600000001</c:v>
                </c:pt>
                <c:pt idx="4">
                  <c:v>1.0189210133333335</c:v>
                </c:pt>
                <c:pt idx="5">
                  <c:v>0.182358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E7E-47FA-8783-4573F635C9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31758304"/>
        <c:axId val="1831752864"/>
      </c:scatterChart>
      <c:valAx>
        <c:axId val="1831758304"/>
        <c:scaling>
          <c:orientation val="minMax"/>
          <c:max val="5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1752864"/>
        <c:crosses val="autoZero"/>
        <c:crossBetween val="midCat"/>
        <c:majorUnit val="1"/>
      </c:valAx>
      <c:valAx>
        <c:axId val="1831752864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1758304"/>
        <c:crosses val="autoZero"/>
        <c:crossBetween val="midCat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6:$J$6</c:f>
                <c:numCache>
                  <c:formatCode>General</c:formatCode>
                  <c:ptCount val="2"/>
                  <c:pt idx="0">
                    <c:v>0.51923019942988669</c:v>
                  </c:pt>
                  <c:pt idx="1">
                    <c:v>1.5849290204927124</c:v>
                  </c:pt>
                </c:numCache>
              </c:numRef>
            </c:plus>
            <c:minus>
              <c:numRef>
                <c:f>Sheet1!$H$6:$J$6</c:f>
                <c:numCache>
                  <c:formatCode>General</c:formatCode>
                  <c:ptCount val="2"/>
                  <c:pt idx="0">
                    <c:v>0.51923019942988669</c:v>
                  </c:pt>
                  <c:pt idx="1">
                    <c:v>1.58492902049271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H$2:$J$2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Sheet1!$H$3:$J$3</c:f>
              <c:numCache>
                <c:formatCode>General</c:formatCode>
                <c:ptCount val="2"/>
                <c:pt idx="0">
                  <c:v>30.74</c:v>
                </c:pt>
                <c:pt idx="1">
                  <c:v>21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17-45D8-9DCC-FC596439788B}"/>
            </c:ext>
          </c:extLst>
        </c:ser>
        <c:ser>
          <c:idx val="1"/>
          <c:order val="1"/>
          <c:tx>
            <c:strRef>
              <c:f>Sheet1!$G$4</c:f>
              <c:strCache>
                <c:ptCount val="1"/>
                <c:pt idx="0">
                  <c:v>gslY349*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7:$J$7</c:f>
                <c:numCache>
                  <c:formatCode>General</c:formatCode>
                  <c:ptCount val="2"/>
                  <c:pt idx="0">
                    <c:v>1.361836994650981</c:v>
                  </c:pt>
                  <c:pt idx="1">
                    <c:v>1.0240117186829456</c:v>
                  </c:pt>
                </c:numCache>
              </c:numRef>
            </c:plus>
            <c:minus>
              <c:numRef>
                <c:f>Sheet1!$H$7:$J$7</c:f>
                <c:numCache>
                  <c:formatCode>General</c:formatCode>
                  <c:ptCount val="2"/>
                  <c:pt idx="0">
                    <c:v>1.361836994650981</c:v>
                  </c:pt>
                  <c:pt idx="1">
                    <c:v>1.02401171868294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H$2:$J$2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Sheet1!$H$4:$J$4</c:f>
              <c:numCache>
                <c:formatCode>General</c:formatCode>
                <c:ptCount val="2"/>
                <c:pt idx="0">
                  <c:v>18.939999999999998</c:v>
                </c:pt>
                <c:pt idx="1">
                  <c:v>2.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717-45D8-9DCC-FC59643978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1755040"/>
        <c:axId val="1831755584"/>
      </c:barChart>
      <c:catAx>
        <c:axId val="1831755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1755584"/>
        <c:crosses val="autoZero"/>
        <c:auto val="1"/>
        <c:lblAlgn val="ctr"/>
        <c:lblOffset val="100"/>
        <c:noMultiLvlLbl val="0"/>
      </c:catAx>
      <c:valAx>
        <c:axId val="18317555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1755040"/>
        <c:crosses val="autoZero"/>
        <c:crossBetween val="between"/>
        <c:majorUnit val="10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H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I$5:$J$5</c:f>
                <c:numCache>
                  <c:formatCode>General</c:formatCode>
                  <c:ptCount val="2"/>
                  <c:pt idx="0">
                    <c:v>4.1062933687806887E-3</c:v>
                  </c:pt>
                  <c:pt idx="1">
                    <c:v>4.1509107611466305E-2</c:v>
                  </c:pt>
                </c:numCache>
              </c:numRef>
            </c:plus>
            <c:minus>
              <c:numRef>
                <c:f>Sheet2!$I$5:$J$5</c:f>
                <c:numCache>
                  <c:formatCode>General</c:formatCode>
                  <c:ptCount val="2"/>
                  <c:pt idx="0">
                    <c:v>4.1062933687806887E-3</c:v>
                  </c:pt>
                  <c:pt idx="1">
                    <c:v>4.150910761146630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I$1:$J$1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Sheet2!$I$2:$J$2</c:f>
              <c:numCache>
                <c:formatCode>#,##0.000</c:formatCode>
                <c:ptCount val="2"/>
                <c:pt idx="0">
                  <c:v>8.6561267011504156E-2</c:v>
                </c:pt>
                <c:pt idx="1">
                  <c:v>0.328358593393229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08-47DB-BB12-7E6A0EFEE68F}"/>
            </c:ext>
          </c:extLst>
        </c:ser>
        <c:ser>
          <c:idx val="1"/>
          <c:order val="1"/>
          <c:tx>
            <c:strRef>
              <c:f>Sheet2!$H$3</c:f>
              <c:strCache>
                <c:ptCount val="1"/>
                <c:pt idx="0">
                  <c:v>gslY349*</c:v>
                </c:pt>
              </c:strCache>
            </c:strRef>
          </c:tx>
          <c:spPr>
            <a:solidFill>
              <a:sysClr val="window" lastClr="FFFFFF"/>
            </a:solidFill>
            <a:ln w="952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I$6:$J$6</c:f>
                <c:numCache>
                  <c:formatCode>General</c:formatCode>
                  <c:ptCount val="2"/>
                  <c:pt idx="0">
                    <c:v>2.6563832080230183E-2</c:v>
                  </c:pt>
                  <c:pt idx="1">
                    <c:v>0.15679299565106619</c:v>
                  </c:pt>
                </c:numCache>
              </c:numRef>
            </c:plus>
            <c:minus>
              <c:numRef>
                <c:f>Sheet2!$I$6:$J$6</c:f>
                <c:numCache>
                  <c:formatCode>General</c:formatCode>
                  <c:ptCount val="2"/>
                  <c:pt idx="0">
                    <c:v>2.6563832080230183E-2</c:v>
                  </c:pt>
                  <c:pt idx="1">
                    <c:v>0.156792995651066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I$1:$J$1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Sheet2!$I$3:$J$3</c:f>
              <c:numCache>
                <c:formatCode>#,##0.000</c:formatCode>
                <c:ptCount val="2"/>
                <c:pt idx="0">
                  <c:v>0.11749896666892427</c:v>
                </c:pt>
                <c:pt idx="1">
                  <c:v>1.00002229619677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08-47DB-BB12-7E6A0EFEE6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2523184"/>
        <c:axId val="1832523728"/>
      </c:barChart>
      <c:catAx>
        <c:axId val="1832523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2523728"/>
        <c:crosses val="autoZero"/>
        <c:auto val="1"/>
        <c:lblAlgn val="ctr"/>
        <c:lblOffset val="100"/>
        <c:noMultiLvlLbl val="0"/>
      </c:catAx>
      <c:valAx>
        <c:axId val="1832523728"/>
        <c:scaling>
          <c:orientation val="minMax"/>
          <c:max val="1.5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2523184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L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M$5:$N$5</c:f>
                <c:numCache>
                  <c:formatCode>General</c:formatCode>
                  <c:ptCount val="2"/>
                  <c:pt idx="0">
                    <c:v>9.346762817389425E-3</c:v>
                  </c:pt>
                  <c:pt idx="1">
                    <c:v>5.2947252826638425E-2</c:v>
                  </c:pt>
                </c:numCache>
              </c:numRef>
            </c:plus>
            <c:minus>
              <c:numRef>
                <c:f>Sheet2!$M$5:$N$5</c:f>
                <c:numCache>
                  <c:formatCode>General</c:formatCode>
                  <c:ptCount val="2"/>
                  <c:pt idx="0">
                    <c:v>9.346762817389425E-3</c:v>
                  </c:pt>
                  <c:pt idx="1">
                    <c:v>5.294725282663842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M$1:$N$1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Sheet2!$M$2:$N$2</c:f>
              <c:numCache>
                <c:formatCode>#,##0.000</c:formatCode>
                <c:ptCount val="2"/>
                <c:pt idx="0">
                  <c:v>0.16055857925376299</c:v>
                </c:pt>
                <c:pt idx="1">
                  <c:v>0.49502889530515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65-455D-AD2D-F60728103C46}"/>
            </c:ext>
          </c:extLst>
        </c:ser>
        <c:ser>
          <c:idx val="1"/>
          <c:order val="1"/>
          <c:tx>
            <c:strRef>
              <c:f>Sheet2!$L$3</c:f>
              <c:strCache>
                <c:ptCount val="1"/>
                <c:pt idx="0">
                  <c:v>gslY349*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M$6:$N$6</c:f>
                <c:numCache>
                  <c:formatCode>General</c:formatCode>
                  <c:ptCount val="2"/>
                  <c:pt idx="0">
                    <c:v>3.6339152028827024E-2</c:v>
                  </c:pt>
                  <c:pt idx="1">
                    <c:v>9.7422321058808631E-2</c:v>
                  </c:pt>
                </c:numCache>
              </c:numRef>
            </c:plus>
            <c:minus>
              <c:numRef>
                <c:f>Sheet2!$M$6:$N$6</c:f>
                <c:numCache>
                  <c:formatCode>General</c:formatCode>
                  <c:ptCount val="2"/>
                  <c:pt idx="0">
                    <c:v>3.6339152028827024E-2</c:v>
                  </c:pt>
                  <c:pt idx="1">
                    <c:v>9.742232105880863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M$1:$N$1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Sheet2!$M$3:$N$3</c:f>
              <c:numCache>
                <c:formatCode>#,##0.000</c:formatCode>
                <c:ptCount val="2"/>
                <c:pt idx="0">
                  <c:v>0.23441426481196581</c:v>
                </c:pt>
                <c:pt idx="1">
                  <c:v>1.0000584814785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65-455D-AD2D-F60728103C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2526448"/>
        <c:axId val="1832524272"/>
      </c:barChart>
      <c:catAx>
        <c:axId val="1832526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2524272"/>
        <c:crosses val="autoZero"/>
        <c:auto val="1"/>
        <c:lblAlgn val="ctr"/>
        <c:lblOffset val="100"/>
        <c:noMultiLvlLbl val="0"/>
      </c:catAx>
      <c:valAx>
        <c:axId val="1832524272"/>
        <c:scaling>
          <c:orientation val="minMax"/>
          <c:max val="1.5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2526448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AG!$H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both"/>
            <c:errValType val="stdErr"/>
            <c:noEndCap val="0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</c:spPr>
          </c:errBars>
          <c:cat>
            <c:numRef>
              <c:f>SAG!$I$1:$J$1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SAG!$I$2:$J$2</c:f>
              <c:numCache>
                <c:formatCode>#,##0.000</c:formatCode>
                <c:ptCount val="2"/>
                <c:pt idx="0">
                  <c:v>0.21474689754291978</c:v>
                </c:pt>
                <c:pt idx="1">
                  <c:v>0.523198939344709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7B-4496-AC99-3363BC9DA6F5}"/>
            </c:ext>
          </c:extLst>
        </c:ser>
        <c:ser>
          <c:idx val="1"/>
          <c:order val="1"/>
          <c:tx>
            <c:strRef>
              <c:f>SAG!$H$3</c:f>
              <c:strCache>
                <c:ptCount val="1"/>
                <c:pt idx="0">
                  <c:v>gslY349*</c:v>
                </c:pt>
              </c:strCache>
            </c:strRef>
          </c:tx>
          <c:spPr>
            <a:solidFill>
              <a:sysClr val="window" lastClr="FFFFFF"/>
            </a:solidFill>
            <a:ln w="952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AG!$I$6:$J$6</c:f>
                <c:numCache>
                  <c:formatCode>General</c:formatCode>
                  <c:ptCount val="2"/>
                  <c:pt idx="0">
                    <c:v>7.4130912893341158E-2</c:v>
                  </c:pt>
                  <c:pt idx="1">
                    <c:v>0.14901013012804817</c:v>
                  </c:pt>
                </c:numCache>
              </c:numRef>
            </c:plus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</c:spPr>
          </c:errBars>
          <c:cat>
            <c:numRef>
              <c:f>SAG!$I$1:$J$1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SAG!$I$3:$J$3</c:f>
              <c:numCache>
                <c:formatCode>#,##0.000</c:formatCode>
                <c:ptCount val="2"/>
                <c:pt idx="0">
                  <c:v>0.29296999821797415</c:v>
                </c:pt>
                <c:pt idx="1">
                  <c:v>0.999967762873273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47B-4496-AC99-3363BC9DA6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2526992"/>
        <c:axId val="1832524816"/>
      </c:barChart>
      <c:catAx>
        <c:axId val="1832526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2524816"/>
        <c:crosses val="autoZero"/>
        <c:auto val="1"/>
        <c:lblAlgn val="ctr"/>
        <c:lblOffset val="100"/>
        <c:noMultiLvlLbl val="0"/>
      </c:catAx>
      <c:valAx>
        <c:axId val="1832524816"/>
        <c:scaling>
          <c:orientation val="minMax"/>
          <c:max val="1.5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2526992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0824 NAC021 31'!$F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 w="25400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200824 NAC021 31'!$G$5:$H$5</c:f>
                <c:numCache>
                  <c:formatCode>General</c:formatCode>
                  <c:ptCount val="2"/>
                  <c:pt idx="0">
                    <c:v>3.9352224967514289E-2</c:v>
                  </c:pt>
                  <c:pt idx="1">
                    <c:v>5.1809703556075774E-2</c:v>
                  </c:pt>
                </c:numCache>
              </c:numRef>
            </c:plus>
            <c:minus>
              <c:numRef>
                <c:f>'200824 NAC021 31'!$G$6:$H$6</c:f>
                <c:numCache>
                  <c:formatCode>General</c:formatCode>
                  <c:ptCount val="2"/>
                  <c:pt idx="0">
                    <c:v>0.10933571627587159</c:v>
                  </c:pt>
                  <c:pt idx="1">
                    <c:v>8.8201657012377199E-2</c:v>
                  </c:pt>
                </c:numCache>
              </c:numRef>
            </c:minus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</c:spPr>
          </c:errBars>
          <c:cat>
            <c:numRef>
              <c:f>'200824 NAC021 31'!$G$1:$H$1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'200824 NAC021 31'!$G$2:$H$2</c:f>
              <c:numCache>
                <c:formatCode>#,##0.000</c:formatCode>
                <c:ptCount val="2"/>
                <c:pt idx="0">
                  <c:v>0.145775280658554</c:v>
                </c:pt>
                <c:pt idx="1">
                  <c:v>0.476203630555350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07-4B1D-9152-8BFB98433F3C}"/>
            </c:ext>
          </c:extLst>
        </c:ser>
        <c:ser>
          <c:idx val="1"/>
          <c:order val="1"/>
          <c:tx>
            <c:strRef>
              <c:f>'200824 NAC021 31'!$F$3</c:f>
              <c:strCache>
                <c:ptCount val="1"/>
                <c:pt idx="0">
                  <c:v>gslY349*</c:v>
                </c:pt>
              </c:strCache>
            </c:strRef>
          </c:tx>
          <c:spPr>
            <a:solidFill>
              <a:sysClr val="window" lastClr="FFFFFF"/>
            </a:solidFill>
            <a:ln w="9525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200824 NAC021 31'!$G$6:$H$6</c:f>
                <c:numCache>
                  <c:formatCode>General</c:formatCode>
                  <c:ptCount val="2"/>
                  <c:pt idx="0">
                    <c:v>0.10933571627587159</c:v>
                  </c:pt>
                  <c:pt idx="1">
                    <c:v>8.8201657012377199E-2</c:v>
                  </c:pt>
                </c:numCache>
              </c:numRef>
            </c:plus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</c:spPr>
          </c:errBars>
          <c:cat>
            <c:numRef>
              <c:f>'200824 NAC021 31'!$G$1:$H$1</c:f>
              <c:numCache>
                <c:formatCode>General</c:formatCode>
                <c:ptCount val="2"/>
                <c:pt idx="0">
                  <c:v>0</c:v>
                </c:pt>
                <c:pt idx="1">
                  <c:v>4</c:v>
                </c:pt>
              </c:numCache>
            </c:numRef>
          </c:cat>
          <c:val>
            <c:numRef>
              <c:f>'200824 NAC021 31'!$G$3:$H$3</c:f>
              <c:numCache>
                <c:formatCode>#,##0.000</c:formatCode>
                <c:ptCount val="2"/>
                <c:pt idx="0">
                  <c:v>0.28956951585205848</c:v>
                </c:pt>
                <c:pt idx="1">
                  <c:v>0.999967143220721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07-4B1D-9152-8BFB98433F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32525360"/>
        <c:axId val="1832525904"/>
      </c:barChart>
      <c:catAx>
        <c:axId val="1832525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2525904"/>
        <c:crosses val="autoZero"/>
        <c:auto val="1"/>
        <c:lblAlgn val="ctr"/>
        <c:lblOffset val="100"/>
        <c:noMultiLvlLbl val="0"/>
      </c:catAx>
      <c:valAx>
        <c:axId val="1832525904"/>
        <c:scaling>
          <c:orientation val="minMax"/>
          <c:max val="1.5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832525360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605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529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1248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532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818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774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3418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5865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4175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282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586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7B776-3ECA-47F9-ADA1-7E4A03F2C56C}" type="datetimeFigureOut">
              <a:rPr kumimoji="1" lang="ja-JP" altLang="en-US" smtClean="0"/>
              <a:t>2021/1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4AE4EB-F817-4CBB-8338-DA01BAF2B0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599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7" Type="http://schemas.openxmlformats.org/officeDocument/2006/relationships/chart" Target="../charts/chart9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正方形/長方形 12"/>
          <p:cNvSpPr/>
          <p:nvPr/>
        </p:nvSpPr>
        <p:spPr>
          <a:xfrm>
            <a:off x="718555" y="5156806"/>
            <a:ext cx="559334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1.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Time course of </a:t>
            </a:r>
            <a:r>
              <a:rPr lang="en-US" altLang="ja-JP" sz="1200" dirty="0" err="1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Chl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content in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els1-2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during natural leaf senescence The </a:t>
            </a:r>
            <a:r>
              <a:rPr lang="en-US" altLang="ja-JP" sz="1200" dirty="0" err="1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Chl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contents of the upper 4th leaves were measured from flowering by acetone extraction. Solid line, WT; dot line,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els1-2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. Error bars indicate standard error (SE) (n=5</a:t>
            </a:r>
            <a:r>
              <a:rPr lang="ja-JP" altLang="en-US" sz="1200" dirty="0"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ea typeface="ＭＳ 明朝" panose="02020609040205080304" pitchFamily="17" charset="-128"/>
                <a:cs typeface="Times New Roman" panose="02020603050405020304" pitchFamily="18" charset="0"/>
              </a:rPr>
              <a:t>biological replicates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).</a:t>
            </a:r>
            <a:endParaRPr lang="ja-JP" altLang="ja-JP" sz="1200" dirty="0">
              <a:effectLst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365951" y="375601"/>
            <a:ext cx="6127899" cy="4332584"/>
            <a:chOff x="35751" y="375601"/>
            <a:chExt cx="6127899" cy="4332584"/>
          </a:xfrm>
        </p:grpSpPr>
        <p:graphicFrame>
          <p:nvGraphicFramePr>
            <p:cNvPr id="4" name="グラフ 3"/>
            <p:cNvGraphicFramePr>
              <a:graphicFrameLocks/>
            </p:cNvGraphicFramePr>
            <p:nvPr/>
          </p:nvGraphicFramePr>
          <p:xfrm>
            <a:off x="380189" y="581070"/>
            <a:ext cx="2703245" cy="18367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グラフ 4"/>
            <p:cNvGraphicFramePr>
              <a:graphicFrameLocks/>
            </p:cNvGraphicFramePr>
            <p:nvPr/>
          </p:nvGraphicFramePr>
          <p:xfrm>
            <a:off x="3476736" y="581071"/>
            <a:ext cx="2686914" cy="18367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グラフ 5"/>
            <p:cNvGraphicFramePr>
              <a:graphicFrameLocks/>
            </p:cNvGraphicFramePr>
            <p:nvPr/>
          </p:nvGraphicFramePr>
          <p:xfrm>
            <a:off x="388355" y="2570142"/>
            <a:ext cx="2686914" cy="18367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グラフ 6"/>
            <p:cNvGraphicFramePr>
              <a:graphicFrameLocks/>
            </p:cNvGraphicFramePr>
            <p:nvPr/>
          </p:nvGraphicFramePr>
          <p:xfrm>
            <a:off x="3476736" y="2570142"/>
            <a:ext cx="2686914" cy="18367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8" name="正方形/長方形 7"/>
            <p:cNvSpPr/>
            <p:nvPr/>
          </p:nvSpPr>
          <p:spPr>
            <a:xfrm>
              <a:off x="857779" y="376045"/>
              <a:ext cx="525175" cy="2311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 err="1">
                  <a:solidFill>
                    <a:schemeClr val="tx1"/>
                  </a:solidFill>
                </a:rPr>
                <a:t>Chl</a:t>
              </a:r>
              <a:r>
                <a:rPr kumimoji="1" lang="ja-JP" altLang="en-US" sz="1200" dirty="0">
                  <a:solidFill>
                    <a:schemeClr val="tx1"/>
                  </a:solidFill>
                </a:rPr>
                <a:t> </a:t>
              </a:r>
              <a:r>
                <a:rPr kumimoji="1" lang="en-US" altLang="ja-JP" sz="1200" i="1" dirty="0">
                  <a:solidFill>
                    <a:schemeClr val="tx1"/>
                  </a:solidFill>
                </a:rPr>
                <a:t>a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9" name="正方形/長方形 8"/>
            <p:cNvSpPr/>
            <p:nvPr/>
          </p:nvSpPr>
          <p:spPr>
            <a:xfrm>
              <a:off x="3819550" y="376044"/>
              <a:ext cx="525175" cy="2311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 err="1">
                  <a:solidFill>
                    <a:schemeClr val="tx1"/>
                  </a:solidFill>
                </a:rPr>
                <a:t>Chl</a:t>
              </a:r>
              <a:r>
                <a:rPr kumimoji="1" lang="ja-JP" altLang="en-US" sz="1200" dirty="0">
                  <a:solidFill>
                    <a:schemeClr val="tx1"/>
                  </a:solidFill>
                </a:rPr>
                <a:t> </a:t>
              </a:r>
              <a:r>
                <a:rPr lang="en-US" altLang="ja-JP" sz="1200" i="1" dirty="0">
                  <a:solidFill>
                    <a:schemeClr val="tx1"/>
                  </a:solidFill>
                </a:rPr>
                <a:t>b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10" name="正方形/長方形 9"/>
            <p:cNvSpPr/>
            <p:nvPr/>
          </p:nvSpPr>
          <p:spPr>
            <a:xfrm>
              <a:off x="703570" y="2427048"/>
              <a:ext cx="930379" cy="2311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 err="1">
                  <a:solidFill>
                    <a:schemeClr val="tx1"/>
                  </a:solidFill>
                </a:rPr>
                <a:t>Chl</a:t>
              </a:r>
              <a:r>
                <a:rPr kumimoji="1" lang="ja-JP" altLang="en-US" sz="1200" dirty="0">
                  <a:solidFill>
                    <a:schemeClr val="tx1"/>
                  </a:solidFill>
                </a:rPr>
                <a:t> </a:t>
              </a:r>
              <a:r>
                <a:rPr lang="en-US" altLang="ja-JP" sz="1200" i="1" dirty="0">
                  <a:solidFill>
                    <a:schemeClr val="tx1"/>
                  </a:solidFill>
                </a:rPr>
                <a:t>a/b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11" name="正方形/長方形 10"/>
            <p:cNvSpPr/>
            <p:nvPr/>
          </p:nvSpPr>
          <p:spPr>
            <a:xfrm>
              <a:off x="3608024" y="2427047"/>
              <a:ext cx="1125760" cy="2311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solidFill>
                    <a:schemeClr val="tx1"/>
                  </a:solidFill>
                </a:rPr>
                <a:t>Total </a:t>
              </a:r>
              <a:r>
                <a:rPr kumimoji="1" lang="en-US" altLang="ja-JP" sz="1200" dirty="0" err="1">
                  <a:solidFill>
                    <a:schemeClr val="tx1"/>
                  </a:solidFill>
                </a:rPr>
                <a:t>Chl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12" name="正方形/長方形 11"/>
            <p:cNvSpPr/>
            <p:nvPr/>
          </p:nvSpPr>
          <p:spPr>
            <a:xfrm>
              <a:off x="2057755" y="4477015"/>
              <a:ext cx="1994353" cy="23117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solidFill>
                    <a:schemeClr val="tx1"/>
                  </a:solidFill>
                </a:rPr>
                <a:t>WAF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15" name="正方形/長方形 14"/>
            <p:cNvSpPr/>
            <p:nvPr/>
          </p:nvSpPr>
          <p:spPr>
            <a:xfrm rot="16200000">
              <a:off x="-654905" y="1066700"/>
              <a:ext cx="1836869" cy="4555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 err="1">
                  <a:solidFill>
                    <a:schemeClr val="tx1"/>
                  </a:solidFill>
                </a:rPr>
                <a:t>Chl</a:t>
              </a:r>
              <a:r>
                <a:rPr kumimoji="1" lang="ja-JP" altLang="en-US" sz="1200" dirty="0">
                  <a:solidFill>
                    <a:schemeClr val="tx1"/>
                  </a:solidFill>
                </a:rPr>
                <a:t> 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content (</a:t>
              </a:r>
              <a:r>
                <a:rPr kumimoji="1" lang="en-US" altLang="ja-JP" sz="1200" dirty="0" err="1">
                  <a:solidFill>
                    <a:schemeClr val="tx1"/>
                  </a:solidFill>
                </a:rPr>
                <a:t>nmol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/ </a:t>
              </a:r>
              <a:r>
                <a:rPr kumimoji="1" lang="en-US" altLang="ja-JP" sz="1200" dirty="0" err="1">
                  <a:solidFill>
                    <a:schemeClr val="tx1"/>
                  </a:solidFill>
                </a:rPr>
                <a:t>mgFW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)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 rot="16200000">
              <a:off x="2461811" y="1066257"/>
              <a:ext cx="1836869" cy="4555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 err="1">
                  <a:solidFill>
                    <a:schemeClr val="tx1"/>
                  </a:solidFill>
                </a:rPr>
                <a:t>Chl</a:t>
              </a:r>
              <a:r>
                <a:rPr kumimoji="1" lang="ja-JP" altLang="en-US" sz="1200" dirty="0">
                  <a:solidFill>
                    <a:schemeClr val="tx1"/>
                  </a:solidFill>
                </a:rPr>
                <a:t> 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content (</a:t>
              </a:r>
              <a:r>
                <a:rPr kumimoji="1" lang="en-US" altLang="ja-JP" sz="1200" dirty="0" err="1">
                  <a:solidFill>
                    <a:schemeClr val="tx1"/>
                  </a:solidFill>
                </a:rPr>
                <a:t>nmol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/ </a:t>
              </a:r>
              <a:r>
                <a:rPr kumimoji="1" lang="en-US" altLang="ja-JP" sz="1200" dirty="0" err="1">
                  <a:solidFill>
                    <a:schemeClr val="tx1"/>
                  </a:solidFill>
                </a:rPr>
                <a:t>mgFW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)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" name="正方形/長方形 18"/>
            <p:cNvSpPr/>
            <p:nvPr/>
          </p:nvSpPr>
          <p:spPr>
            <a:xfrm rot="16200000">
              <a:off x="2461810" y="3046221"/>
              <a:ext cx="1836869" cy="4555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 err="1">
                  <a:solidFill>
                    <a:schemeClr val="tx1"/>
                  </a:solidFill>
                </a:rPr>
                <a:t>Chl</a:t>
              </a:r>
              <a:r>
                <a:rPr kumimoji="1" lang="ja-JP" altLang="en-US" sz="1200" dirty="0">
                  <a:solidFill>
                    <a:schemeClr val="tx1"/>
                  </a:solidFill>
                </a:rPr>
                <a:t> 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content (</a:t>
              </a:r>
              <a:r>
                <a:rPr kumimoji="1" lang="en-US" altLang="ja-JP" sz="1200" dirty="0" err="1">
                  <a:solidFill>
                    <a:schemeClr val="tx1"/>
                  </a:solidFill>
                </a:rPr>
                <a:t>nmol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/ </a:t>
              </a:r>
              <a:r>
                <a:rPr kumimoji="1" lang="en-US" altLang="ja-JP" sz="1200" dirty="0" err="1">
                  <a:solidFill>
                    <a:schemeClr val="tx1"/>
                  </a:solidFill>
                </a:rPr>
                <a:t>mgFW</a:t>
              </a:r>
              <a:r>
                <a:rPr kumimoji="1" lang="en-US" altLang="ja-JP" sz="1200" dirty="0">
                  <a:solidFill>
                    <a:schemeClr val="tx1"/>
                  </a:solidFill>
                </a:rPr>
                <a:t>)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694085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正方形/長方形 22"/>
          <p:cNvSpPr/>
          <p:nvPr/>
        </p:nvSpPr>
        <p:spPr>
          <a:xfrm>
            <a:off x="711200" y="6463225"/>
            <a:ext cx="53721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/>
              <a:t>Supplemental Figure 2. </a:t>
            </a:r>
            <a:r>
              <a:rPr lang="en-US" altLang="ja-JP" sz="1200" dirty="0"/>
              <a:t>Phenotype of </a:t>
            </a:r>
            <a:r>
              <a:rPr lang="en-US" altLang="ja-JP" sz="1200" i="1" dirty="0"/>
              <a:t>els1-2</a:t>
            </a:r>
            <a:r>
              <a:rPr lang="en-US" altLang="ja-JP" sz="1200" dirty="0"/>
              <a:t> during dark-induced leaf senescence. </a:t>
            </a:r>
            <a:r>
              <a:rPr lang="en-US" altLang="ja-JP" sz="1200" b="1" dirty="0"/>
              <a:t>(A)</a:t>
            </a:r>
            <a:r>
              <a:rPr lang="en-US" altLang="ja-JP" sz="1200" dirty="0"/>
              <a:t> </a:t>
            </a:r>
            <a:r>
              <a:rPr lang="en-US" altLang="ja-JP" sz="1200" i="1" dirty="0"/>
              <a:t>els1-2</a:t>
            </a:r>
            <a:r>
              <a:rPr lang="en-US" altLang="ja-JP" sz="1200" dirty="0"/>
              <a:t> showed an early senescence phenotype during dark-induced senescence of primary leaves. Scale bar indicates 1 cm. </a:t>
            </a:r>
            <a:r>
              <a:rPr lang="en-US" altLang="ja-JP" sz="1200" b="1" dirty="0"/>
              <a:t>(B)</a:t>
            </a:r>
            <a:r>
              <a:rPr lang="en-US" altLang="ja-JP" sz="1200" dirty="0"/>
              <a:t> Chlorophyll content (SPAD) of primary leaves of WT and </a:t>
            </a:r>
            <a:r>
              <a:rPr lang="en-US" altLang="ja-JP" sz="1200" i="1" dirty="0"/>
              <a:t>els1-2</a:t>
            </a:r>
            <a:r>
              <a:rPr lang="en-US" altLang="ja-JP" sz="1200" dirty="0"/>
              <a:t> (n=5 biological replicates) during dark-induced senescence. Black bars indicate WT, white bars indicate </a:t>
            </a:r>
            <a:r>
              <a:rPr lang="en-US" altLang="ja-JP" sz="1200" i="1" dirty="0"/>
              <a:t>els1-2</a:t>
            </a:r>
            <a:r>
              <a:rPr lang="en-US" altLang="ja-JP" sz="1200" dirty="0"/>
              <a:t>. Error bars indicate standard errors (SE). *P &lt; 0.05, **P &lt; 0.01, </a:t>
            </a:r>
            <a:r>
              <a:rPr lang="en-US" altLang="ja-JP" sz="1200" dirty="0" err="1"/>
              <a:t>n.s</a:t>
            </a:r>
            <a:r>
              <a:rPr lang="en-US" altLang="ja-JP" sz="1200" dirty="0"/>
              <a:t>., not significant (Student's t-test). </a:t>
            </a:r>
            <a:r>
              <a:rPr lang="en-US" altLang="ja-JP" sz="1200" b="1" dirty="0"/>
              <a:t>(C)</a:t>
            </a:r>
            <a:r>
              <a:rPr lang="en-US" altLang="ja-JP" sz="1200" dirty="0"/>
              <a:t> Expression pattern of senescence-inducible genes in WT and </a:t>
            </a:r>
            <a:r>
              <a:rPr lang="en-US" altLang="ja-JP" sz="1200" i="1" dirty="0"/>
              <a:t>els1-2</a:t>
            </a:r>
            <a:r>
              <a:rPr lang="en-US" altLang="ja-JP" sz="1200" dirty="0"/>
              <a:t> during dark-induced leaf senescence. Total RNA from the primary leaves of WT and </a:t>
            </a:r>
            <a:r>
              <a:rPr lang="en-US" altLang="ja-JP" sz="1200" i="1" dirty="0"/>
              <a:t>els1-2</a:t>
            </a:r>
            <a:r>
              <a:rPr lang="en-US" altLang="ja-JP" sz="1200" dirty="0"/>
              <a:t> was examined. Expression levels were standardized using actin (n=6 biological replicates). </a:t>
            </a: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F6E72551-8F53-4A83-B434-85E421368CEE}"/>
              </a:ext>
            </a:extLst>
          </p:cNvPr>
          <p:cNvGrpSpPr/>
          <p:nvPr/>
        </p:nvGrpSpPr>
        <p:grpSpPr>
          <a:xfrm>
            <a:off x="393700" y="520760"/>
            <a:ext cx="5778746" cy="5525961"/>
            <a:chOff x="0" y="520760"/>
            <a:chExt cx="5778746" cy="5525961"/>
          </a:xfrm>
        </p:grpSpPr>
        <p:sp>
          <p:nvSpPr>
            <p:cNvPr id="7" name="正方形/長方形 6"/>
            <p:cNvSpPr/>
            <p:nvPr/>
          </p:nvSpPr>
          <p:spPr>
            <a:xfrm rot="16200000">
              <a:off x="2521141" y="1356275"/>
              <a:ext cx="1936925" cy="2658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Chlorophyll</a:t>
              </a:r>
              <a:r>
                <a:rPr lang="ja-JP" altLang="en-US" sz="1200" dirty="0">
                  <a:solidFill>
                    <a:schemeClr val="tx1"/>
                  </a:solidFill>
                </a:rPr>
                <a:t> </a:t>
              </a:r>
              <a:r>
                <a:rPr lang="en-US" altLang="ja-JP" sz="1200" dirty="0">
                  <a:solidFill>
                    <a:schemeClr val="tx1"/>
                  </a:solidFill>
                </a:rPr>
                <a:t>content (SPAD)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3" name="正方形/長方形 12"/>
            <p:cNvSpPr/>
            <p:nvPr/>
          </p:nvSpPr>
          <p:spPr>
            <a:xfrm>
              <a:off x="4261779" y="2408703"/>
              <a:ext cx="927546" cy="23548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200" dirty="0">
                  <a:solidFill>
                    <a:schemeClr val="tx1"/>
                  </a:solidFill>
                </a:rPr>
                <a:t>DAD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5609" y="520760"/>
              <a:ext cx="563036" cy="1681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600" dirty="0">
                  <a:solidFill>
                    <a:schemeClr val="tx1"/>
                  </a:solidFill>
                </a:rPr>
                <a:t>A</a:t>
              </a:r>
              <a:endParaRPr kumimoji="1" lang="ja-JP" altLang="en-US" sz="1600" dirty="0">
                <a:solidFill>
                  <a:schemeClr val="tx1"/>
                </a:solidFill>
              </a:endParaRPr>
            </a:p>
          </p:txBody>
        </p:sp>
        <p:sp>
          <p:nvSpPr>
            <p:cNvPr id="25" name="正方形/長方形 24"/>
            <p:cNvSpPr/>
            <p:nvPr/>
          </p:nvSpPr>
          <p:spPr>
            <a:xfrm>
              <a:off x="0" y="3006657"/>
              <a:ext cx="563036" cy="1681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600" dirty="0">
                  <a:solidFill>
                    <a:schemeClr val="tx1"/>
                  </a:solidFill>
                </a:rPr>
                <a:t>C</a:t>
              </a:r>
              <a:endParaRPr kumimoji="1" lang="ja-JP" altLang="en-US" sz="1600" dirty="0">
                <a:solidFill>
                  <a:schemeClr val="tx1"/>
                </a:solidFill>
              </a:endParaRPr>
            </a:p>
          </p:txBody>
        </p:sp>
        <p:grpSp>
          <p:nvGrpSpPr>
            <p:cNvPr id="2" name="グループ化 1"/>
            <p:cNvGrpSpPr>
              <a:grpSpLocks noChangeAspect="1"/>
            </p:cNvGrpSpPr>
            <p:nvPr/>
          </p:nvGrpSpPr>
          <p:grpSpPr>
            <a:xfrm>
              <a:off x="556634" y="742730"/>
              <a:ext cx="2187103" cy="1645422"/>
              <a:chOff x="719689" y="852471"/>
              <a:chExt cx="2646395" cy="1990960"/>
            </a:xfrm>
          </p:grpSpPr>
          <p:grpSp>
            <p:nvGrpSpPr>
              <p:cNvPr id="8" name="グループ化 7"/>
              <p:cNvGrpSpPr>
                <a:grpSpLocks noChangeAspect="1"/>
              </p:cNvGrpSpPr>
              <p:nvPr/>
            </p:nvGrpSpPr>
            <p:grpSpPr>
              <a:xfrm>
                <a:off x="732877" y="852471"/>
                <a:ext cx="2620021" cy="1652537"/>
                <a:chOff x="1307137" y="711200"/>
                <a:chExt cx="6795655" cy="4286250"/>
              </a:xfrm>
            </p:grpSpPr>
            <p:pic>
              <p:nvPicPr>
                <p:cNvPr id="9" name="図 8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307137" y="1176675"/>
                  <a:ext cx="6795655" cy="3820775"/>
                </a:xfrm>
                <a:prstGeom prst="rect">
                  <a:avLst/>
                </a:prstGeom>
              </p:spPr>
            </p:pic>
            <p:cxnSp>
              <p:nvCxnSpPr>
                <p:cNvPr id="10" name="直線コネクタ 9"/>
                <p:cNvCxnSpPr/>
                <p:nvPr/>
              </p:nvCxnSpPr>
              <p:spPr>
                <a:xfrm flipV="1">
                  <a:off x="6788894" y="4743835"/>
                  <a:ext cx="611573" cy="6927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" name="正方形/長方形 10"/>
                <p:cNvSpPr/>
                <p:nvPr/>
              </p:nvSpPr>
              <p:spPr>
                <a:xfrm>
                  <a:off x="2438400" y="711200"/>
                  <a:ext cx="1365250" cy="3937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1200" dirty="0">
                      <a:solidFill>
                        <a:schemeClr val="tx1"/>
                      </a:solidFill>
                    </a:rPr>
                    <a:t>WT</a:t>
                  </a:r>
                  <a:endParaRPr kumimoji="1" lang="ja-JP" altLang="en-US" sz="120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2" name="正方形/長方形 11"/>
                <p:cNvSpPr/>
                <p:nvPr/>
              </p:nvSpPr>
              <p:spPr>
                <a:xfrm>
                  <a:off x="5312681" y="711200"/>
                  <a:ext cx="2198749" cy="393699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ja-JP" sz="1200" i="1" dirty="0">
                      <a:solidFill>
                        <a:schemeClr val="tx1"/>
                      </a:solidFill>
                    </a:rPr>
                    <a:t>els1-2</a:t>
                  </a:r>
                  <a:endParaRPr kumimoji="1" lang="ja-JP" altLang="en-US" sz="1200" i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26" name="正方形/長方形 25"/>
              <p:cNvSpPr/>
              <p:nvPr/>
            </p:nvSpPr>
            <p:spPr>
              <a:xfrm>
                <a:off x="719689" y="2521697"/>
                <a:ext cx="2646395" cy="32173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200" dirty="0">
                    <a:solidFill>
                      <a:schemeClr val="tx1"/>
                    </a:solidFill>
                  </a:rPr>
                  <a:t>4 DAD</a:t>
                </a:r>
                <a:endParaRPr kumimoji="1" lang="ja-JP" altLang="en-US" sz="1200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27" name="正方形/長方形 26"/>
            <p:cNvSpPr/>
            <p:nvPr/>
          </p:nvSpPr>
          <p:spPr>
            <a:xfrm>
              <a:off x="2926567" y="520760"/>
              <a:ext cx="563036" cy="1681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600" dirty="0">
                  <a:solidFill>
                    <a:schemeClr val="tx1"/>
                  </a:solidFill>
                </a:rPr>
                <a:t>B</a:t>
              </a:r>
              <a:endParaRPr kumimoji="1" lang="ja-JP" altLang="en-US" sz="1600" dirty="0">
                <a:solidFill>
                  <a:schemeClr val="tx1"/>
                </a:solidFill>
              </a:endParaRPr>
            </a:p>
          </p:txBody>
        </p:sp>
        <p:grpSp>
          <p:nvGrpSpPr>
            <p:cNvPr id="3" name="グループ化 2"/>
            <p:cNvGrpSpPr/>
            <p:nvPr/>
          </p:nvGrpSpPr>
          <p:grpSpPr>
            <a:xfrm>
              <a:off x="3548768" y="692770"/>
              <a:ext cx="2229978" cy="1715266"/>
              <a:chOff x="3564182" y="-921284"/>
              <a:chExt cx="2229978" cy="1715266"/>
            </a:xfrm>
          </p:grpSpPr>
          <p:grpSp>
            <p:nvGrpSpPr>
              <p:cNvPr id="14" name="グループ化 13"/>
              <p:cNvGrpSpPr/>
              <p:nvPr/>
            </p:nvGrpSpPr>
            <p:grpSpPr>
              <a:xfrm>
                <a:off x="4121519" y="-631856"/>
                <a:ext cx="462717" cy="57891"/>
                <a:chOff x="5769002" y="645328"/>
                <a:chExt cx="596922" cy="131260"/>
              </a:xfrm>
            </p:grpSpPr>
            <p:sp>
              <p:nvSpPr>
                <p:cNvPr id="15" name="正方形/長方形 14"/>
                <p:cNvSpPr/>
                <p:nvPr/>
              </p:nvSpPr>
              <p:spPr bwMode="auto">
                <a:xfrm>
                  <a:off x="5769002" y="645328"/>
                  <a:ext cx="596922" cy="108233"/>
                </a:xfrm>
                <a:prstGeom prst="rect">
                  <a:avLst/>
                </a:prstGeom>
                <a:noFill/>
                <a:ln w="12700" cap="flat" cmpd="sng" algn="ctr">
                  <a:noFill/>
                  <a:prstDash val="solid"/>
                </a:ln>
                <a:effectLst/>
              </p:spPr>
              <p:txBody>
                <a:bodyPr anchor="ctr"/>
                <a:lstStyle/>
                <a:p>
                  <a:pPr algn="ctr">
                    <a:defRPr/>
                  </a:pPr>
                  <a:r>
                    <a:rPr kumimoji="0" lang="en-US" altLang="ja-JP" sz="1200" kern="0" dirty="0">
                      <a:solidFill>
                        <a:sysClr val="windowText" lastClr="000000"/>
                      </a:solidFill>
                      <a:ea typeface="Arial Unicode MS" pitchFamily="50" charset="-128"/>
                      <a:cs typeface="Arial Unicode MS" pitchFamily="50" charset="-128"/>
                    </a:rPr>
                    <a:t>**</a:t>
                  </a:r>
                </a:p>
              </p:txBody>
            </p:sp>
            <p:cxnSp>
              <p:nvCxnSpPr>
                <p:cNvPr id="16" name="直線コネクタ 15"/>
                <p:cNvCxnSpPr/>
                <p:nvPr/>
              </p:nvCxnSpPr>
              <p:spPr>
                <a:xfrm>
                  <a:off x="5835921" y="776588"/>
                  <a:ext cx="41436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" name="グループ化 16"/>
              <p:cNvGrpSpPr/>
              <p:nvPr/>
            </p:nvGrpSpPr>
            <p:grpSpPr>
              <a:xfrm>
                <a:off x="4999302" y="-398091"/>
                <a:ext cx="462717" cy="57891"/>
                <a:chOff x="5769002" y="645328"/>
                <a:chExt cx="596922" cy="131260"/>
              </a:xfrm>
            </p:grpSpPr>
            <p:sp>
              <p:nvSpPr>
                <p:cNvPr id="18" name="正方形/長方形 17"/>
                <p:cNvSpPr/>
                <p:nvPr/>
              </p:nvSpPr>
              <p:spPr bwMode="auto">
                <a:xfrm>
                  <a:off x="5769002" y="645328"/>
                  <a:ext cx="596922" cy="108233"/>
                </a:xfrm>
                <a:prstGeom prst="rect">
                  <a:avLst/>
                </a:prstGeom>
                <a:noFill/>
                <a:ln w="12700" cap="flat" cmpd="sng" algn="ctr">
                  <a:noFill/>
                  <a:prstDash val="solid"/>
                </a:ln>
                <a:effectLst/>
              </p:spPr>
              <p:txBody>
                <a:bodyPr anchor="ctr"/>
                <a:lstStyle/>
                <a:p>
                  <a:pPr algn="ctr">
                    <a:defRPr/>
                  </a:pPr>
                  <a:r>
                    <a:rPr kumimoji="0" lang="en-US" altLang="ja-JP" sz="1200" kern="0" dirty="0">
                      <a:solidFill>
                        <a:sysClr val="windowText" lastClr="000000"/>
                      </a:solidFill>
                      <a:ea typeface="Arial Unicode MS" pitchFamily="50" charset="-128"/>
                      <a:cs typeface="Arial Unicode MS" pitchFamily="50" charset="-128"/>
                    </a:rPr>
                    <a:t>**</a:t>
                  </a:r>
                </a:p>
              </p:txBody>
            </p:sp>
            <p:cxnSp>
              <p:nvCxnSpPr>
                <p:cNvPr id="19" name="直線コネクタ 18"/>
                <p:cNvCxnSpPr/>
                <p:nvPr/>
              </p:nvCxnSpPr>
              <p:spPr>
                <a:xfrm>
                  <a:off x="5835921" y="776588"/>
                  <a:ext cx="41436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aphicFrame>
            <p:nvGraphicFramePr>
              <p:cNvPr id="64" name="グラフ 63"/>
              <p:cNvGraphicFramePr>
                <a:graphicFrameLocks/>
              </p:cNvGraphicFramePr>
              <p:nvPr/>
            </p:nvGraphicFramePr>
            <p:xfrm>
              <a:off x="3564182" y="-921284"/>
              <a:ext cx="2229978" cy="171526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aphicFrame>
          <p:nvGraphicFramePr>
            <p:cNvPr id="63" name="グラフ 6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46271971"/>
                </p:ext>
              </p:extLst>
            </p:nvPr>
          </p:nvGraphicFramePr>
          <p:xfrm>
            <a:off x="767983" y="3165639"/>
            <a:ext cx="2307677" cy="14004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5" name="グラフ 6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50772374"/>
                </p:ext>
              </p:extLst>
            </p:nvPr>
          </p:nvGraphicFramePr>
          <p:xfrm>
            <a:off x="3264214" y="3165639"/>
            <a:ext cx="2313305" cy="14004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6" name="正方形/長方形 65"/>
            <p:cNvSpPr/>
            <p:nvPr/>
          </p:nvSpPr>
          <p:spPr>
            <a:xfrm>
              <a:off x="1133424" y="3352336"/>
              <a:ext cx="912398" cy="12024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i="1" dirty="0">
                  <a:solidFill>
                    <a:schemeClr val="tx1"/>
                  </a:solidFill>
                </a:rPr>
                <a:t>GmSGR1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67" name="正方形/長方形 66"/>
            <p:cNvSpPr/>
            <p:nvPr/>
          </p:nvSpPr>
          <p:spPr>
            <a:xfrm>
              <a:off x="3638046" y="3352335"/>
              <a:ext cx="912398" cy="12024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i="1" dirty="0">
                  <a:solidFill>
                    <a:schemeClr val="tx1"/>
                  </a:solidFill>
                </a:rPr>
                <a:t>GmNYC1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68" name="正方形/長方形 67"/>
            <p:cNvSpPr/>
            <p:nvPr/>
          </p:nvSpPr>
          <p:spPr>
            <a:xfrm rot="16200000">
              <a:off x="-276727" y="4398716"/>
              <a:ext cx="1869313" cy="18978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solidFill>
                    <a:schemeClr val="tx1"/>
                  </a:solidFill>
                </a:rPr>
                <a:t>Relative expression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grpSp>
          <p:nvGrpSpPr>
            <p:cNvPr id="69" name="グループ化 68"/>
            <p:cNvGrpSpPr/>
            <p:nvPr/>
          </p:nvGrpSpPr>
          <p:grpSpPr>
            <a:xfrm>
              <a:off x="1453748" y="3946035"/>
              <a:ext cx="397517" cy="91765"/>
              <a:chOff x="317909" y="5344592"/>
              <a:chExt cx="1305275" cy="190486"/>
            </a:xfrm>
          </p:grpSpPr>
          <p:sp>
            <p:nvSpPr>
              <p:cNvPr id="70" name="正方形/長方形 69"/>
              <p:cNvSpPr/>
              <p:nvPr/>
            </p:nvSpPr>
            <p:spPr bwMode="auto">
              <a:xfrm>
                <a:off x="317909" y="5344592"/>
                <a:ext cx="1305275" cy="114696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r>
                  <a:rPr kumimoji="0" lang="en-US" altLang="ja-JP" sz="1200" kern="0" dirty="0" err="1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n.s</a:t>
                </a:r>
                <a:r>
                  <a:rPr kumimoji="0" lang="en-US" altLang="ja-JP" sz="1200" kern="0" dirty="0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.</a:t>
                </a:r>
              </a:p>
            </p:txBody>
          </p:sp>
          <p:cxnSp>
            <p:nvCxnSpPr>
              <p:cNvPr id="71" name="直線コネクタ 70"/>
              <p:cNvCxnSpPr/>
              <p:nvPr/>
            </p:nvCxnSpPr>
            <p:spPr>
              <a:xfrm>
                <a:off x="413609" y="5535078"/>
                <a:ext cx="996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81" name="グラフ 8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08297762"/>
                </p:ext>
              </p:extLst>
            </p:nvPr>
          </p:nvGraphicFramePr>
          <p:xfrm>
            <a:off x="3264214" y="4639629"/>
            <a:ext cx="2307677" cy="14004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82" name="正方形/長方形 81"/>
            <p:cNvSpPr/>
            <p:nvPr/>
          </p:nvSpPr>
          <p:spPr>
            <a:xfrm>
              <a:off x="3618793" y="4822202"/>
              <a:ext cx="912398" cy="12024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i="1" dirty="0">
                  <a:solidFill>
                    <a:schemeClr val="tx1"/>
                  </a:solidFill>
                </a:rPr>
                <a:t>GmSAG15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graphicFrame>
          <p:nvGraphicFramePr>
            <p:cNvPr id="89" name="グラフ 8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3319556"/>
                </p:ext>
              </p:extLst>
            </p:nvPr>
          </p:nvGraphicFramePr>
          <p:xfrm>
            <a:off x="767983" y="4645745"/>
            <a:ext cx="2307677" cy="14009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90" name="正方形/長方形 89"/>
            <p:cNvSpPr/>
            <p:nvPr/>
          </p:nvSpPr>
          <p:spPr>
            <a:xfrm>
              <a:off x="1200803" y="4828837"/>
              <a:ext cx="912398" cy="12024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i="1" dirty="0">
                  <a:solidFill>
                    <a:schemeClr val="tx1"/>
                  </a:solidFill>
                </a:rPr>
                <a:t>GmNAC01</a:t>
              </a:r>
              <a:endParaRPr kumimoji="1" lang="ja-JP" altLang="en-US" sz="1200" i="1" dirty="0">
                <a:solidFill>
                  <a:schemeClr val="tx1"/>
                </a:solidFill>
              </a:endParaRPr>
            </a:p>
          </p:txBody>
        </p:sp>
        <p:grpSp>
          <p:nvGrpSpPr>
            <p:cNvPr id="97" name="グループ化 96"/>
            <p:cNvGrpSpPr/>
            <p:nvPr/>
          </p:nvGrpSpPr>
          <p:grpSpPr>
            <a:xfrm>
              <a:off x="1435905" y="5297700"/>
              <a:ext cx="397517" cy="91765"/>
              <a:chOff x="317909" y="5344592"/>
              <a:chExt cx="1305275" cy="190486"/>
            </a:xfrm>
          </p:grpSpPr>
          <p:sp>
            <p:nvSpPr>
              <p:cNvPr id="98" name="正方形/長方形 97"/>
              <p:cNvSpPr/>
              <p:nvPr/>
            </p:nvSpPr>
            <p:spPr bwMode="auto">
              <a:xfrm>
                <a:off x="317909" y="5344592"/>
                <a:ext cx="1305275" cy="114696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r>
                  <a:rPr kumimoji="0" lang="en-US" altLang="ja-JP" sz="1200" kern="0" dirty="0" err="1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n.s</a:t>
                </a:r>
                <a:r>
                  <a:rPr kumimoji="0" lang="en-US" altLang="ja-JP" sz="1200" kern="0" dirty="0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.</a:t>
                </a:r>
              </a:p>
            </p:txBody>
          </p:sp>
          <p:cxnSp>
            <p:nvCxnSpPr>
              <p:cNvPr id="99" name="直線コネクタ 98"/>
              <p:cNvCxnSpPr/>
              <p:nvPr/>
            </p:nvCxnSpPr>
            <p:spPr>
              <a:xfrm>
                <a:off x="413609" y="5535078"/>
                <a:ext cx="996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グループ化 99"/>
            <p:cNvGrpSpPr/>
            <p:nvPr/>
          </p:nvGrpSpPr>
          <p:grpSpPr>
            <a:xfrm>
              <a:off x="3939946" y="3909524"/>
              <a:ext cx="397517" cy="91765"/>
              <a:chOff x="317909" y="5344592"/>
              <a:chExt cx="1305275" cy="190486"/>
            </a:xfrm>
          </p:grpSpPr>
          <p:sp>
            <p:nvSpPr>
              <p:cNvPr id="101" name="正方形/長方形 100"/>
              <p:cNvSpPr/>
              <p:nvPr/>
            </p:nvSpPr>
            <p:spPr bwMode="auto">
              <a:xfrm>
                <a:off x="317909" y="5344592"/>
                <a:ext cx="1305275" cy="114696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r>
                  <a:rPr kumimoji="0" lang="en-US" altLang="ja-JP" sz="1200" kern="0" dirty="0" err="1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n.s</a:t>
                </a:r>
                <a:r>
                  <a:rPr kumimoji="0" lang="en-US" altLang="ja-JP" sz="1200" kern="0" dirty="0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.</a:t>
                </a:r>
              </a:p>
            </p:txBody>
          </p:sp>
          <p:cxnSp>
            <p:nvCxnSpPr>
              <p:cNvPr id="102" name="直線コネクタ 101"/>
              <p:cNvCxnSpPr/>
              <p:nvPr/>
            </p:nvCxnSpPr>
            <p:spPr>
              <a:xfrm>
                <a:off x="413609" y="5535078"/>
                <a:ext cx="996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3" name="グループ化 102"/>
            <p:cNvGrpSpPr/>
            <p:nvPr/>
          </p:nvGrpSpPr>
          <p:grpSpPr>
            <a:xfrm>
              <a:off x="3965000" y="5300436"/>
              <a:ext cx="397517" cy="91765"/>
              <a:chOff x="317909" y="5344592"/>
              <a:chExt cx="1305275" cy="190486"/>
            </a:xfrm>
          </p:grpSpPr>
          <p:sp>
            <p:nvSpPr>
              <p:cNvPr id="104" name="正方形/長方形 103"/>
              <p:cNvSpPr/>
              <p:nvPr/>
            </p:nvSpPr>
            <p:spPr bwMode="auto">
              <a:xfrm>
                <a:off x="317909" y="5344592"/>
                <a:ext cx="1305275" cy="114696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r>
                  <a:rPr kumimoji="0" lang="en-US" altLang="ja-JP" sz="1200" kern="0" dirty="0" err="1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n.s</a:t>
                </a:r>
                <a:r>
                  <a:rPr kumimoji="0" lang="en-US" altLang="ja-JP" sz="1200" kern="0" dirty="0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.</a:t>
                </a:r>
              </a:p>
            </p:txBody>
          </p:sp>
          <p:cxnSp>
            <p:nvCxnSpPr>
              <p:cNvPr id="105" name="直線コネクタ 104"/>
              <p:cNvCxnSpPr/>
              <p:nvPr/>
            </p:nvCxnSpPr>
            <p:spPr>
              <a:xfrm>
                <a:off x="413609" y="5535078"/>
                <a:ext cx="996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グループ化 105"/>
            <p:cNvGrpSpPr/>
            <p:nvPr/>
          </p:nvGrpSpPr>
          <p:grpSpPr>
            <a:xfrm>
              <a:off x="2294655" y="3388259"/>
              <a:ext cx="397517" cy="75890"/>
              <a:chOff x="276209" y="5377547"/>
              <a:chExt cx="1305275" cy="157531"/>
            </a:xfrm>
          </p:grpSpPr>
          <p:sp>
            <p:nvSpPr>
              <p:cNvPr id="107" name="正方形/長方形 106"/>
              <p:cNvSpPr/>
              <p:nvPr/>
            </p:nvSpPr>
            <p:spPr bwMode="auto">
              <a:xfrm>
                <a:off x="276209" y="5377547"/>
                <a:ext cx="1305275" cy="114695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r>
                  <a:rPr kumimoji="0" lang="en-US" altLang="ja-JP" sz="1200" kern="0" dirty="0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*</a:t>
                </a:r>
              </a:p>
            </p:txBody>
          </p:sp>
          <p:cxnSp>
            <p:nvCxnSpPr>
              <p:cNvPr id="108" name="直線コネクタ 107"/>
              <p:cNvCxnSpPr/>
              <p:nvPr/>
            </p:nvCxnSpPr>
            <p:spPr>
              <a:xfrm>
                <a:off x="413609" y="5535078"/>
                <a:ext cx="996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グループ化 108"/>
            <p:cNvGrpSpPr/>
            <p:nvPr/>
          </p:nvGrpSpPr>
          <p:grpSpPr>
            <a:xfrm>
              <a:off x="2294655" y="4876480"/>
              <a:ext cx="397517" cy="75890"/>
              <a:chOff x="276209" y="5377547"/>
              <a:chExt cx="1305275" cy="157531"/>
            </a:xfrm>
          </p:grpSpPr>
          <p:sp>
            <p:nvSpPr>
              <p:cNvPr id="110" name="正方形/長方形 109"/>
              <p:cNvSpPr/>
              <p:nvPr/>
            </p:nvSpPr>
            <p:spPr bwMode="auto">
              <a:xfrm>
                <a:off x="276209" y="5377547"/>
                <a:ext cx="1305275" cy="114695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r>
                  <a:rPr kumimoji="0" lang="en-US" altLang="ja-JP" sz="1200" kern="0" dirty="0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**</a:t>
                </a:r>
              </a:p>
            </p:txBody>
          </p:sp>
          <p:cxnSp>
            <p:nvCxnSpPr>
              <p:cNvPr id="111" name="直線コネクタ 110"/>
              <p:cNvCxnSpPr/>
              <p:nvPr/>
            </p:nvCxnSpPr>
            <p:spPr>
              <a:xfrm>
                <a:off x="413609" y="5535078"/>
                <a:ext cx="996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グループ化 114"/>
            <p:cNvGrpSpPr/>
            <p:nvPr/>
          </p:nvGrpSpPr>
          <p:grpSpPr>
            <a:xfrm>
              <a:off x="4821441" y="3426204"/>
              <a:ext cx="397517" cy="75890"/>
              <a:chOff x="276209" y="5377547"/>
              <a:chExt cx="1305275" cy="157531"/>
            </a:xfrm>
          </p:grpSpPr>
          <p:sp>
            <p:nvSpPr>
              <p:cNvPr id="116" name="正方形/長方形 115"/>
              <p:cNvSpPr/>
              <p:nvPr/>
            </p:nvSpPr>
            <p:spPr bwMode="auto">
              <a:xfrm>
                <a:off x="276209" y="5377547"/>
                <a:ext cx="1305275" cy="114695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r>
                  <a:rPr kumimoji="0" lang="en-US" altLang="ja-JP" sz="1200" kern="0" dirty="0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**</a:t>
                </a:r>
              </a:p>
            </p:txBody>
          </p:sp>
          <p:cxnSp>
            <p:nvCxnSpPr>
              <p:cNvPr id="117" name="直線コネクタ 116"/>
              <p:cNvCxnSpPr/>
              <p:nvPr/>
            </p:nvCxnSpPr>
            <p:spPr>
              <a:xfrm>
                <a:off x="413609" y="5535078"/>
                <a:ext cx="996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1" name="グループ化 120"/>
            <p:cNvGrpSpPr/>
            <p:nvPr/>
          </p:nvGrpSpPr>
          <p:grpSpPr>
            <a:xfrm>
              <a:off x="4799046" y="4877687"/>
              <a:ext cx="397517" cy="75890"/>
              <a:chOff x="276209" y="5377547"/>
              <a:chExt cx="1305275" cy="157531"/>
            </a:xfrm>
          </p:grpSpPr>
          <p:sp>
            <p:nvSpPr>
              <p:cNvPr id="122" name="正方形/長方形 121"/>
              <p:cNvSpPr/>
              <p:nvPr/>
            </p:nvSpPr>
            <p:spPr bwMode="auto">
              <a:xfrm>
                <a:off x="276209" y="5377547"/>
                <a:ext cx="1305275" cy="114695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algn="ctr">
                  <a:defRPr/>
                </a:pPr>
                <a:r>
                  <a:rPr kumimoji="0" lang="en-US" altLang="ja-JP" sz="1200" kern="0" dirty="0">
                    <a:solidFill>
                      <a:sysClr val="windowText" lastClr="000000"/>
                    </a:solidFill>
                    <a:ea typeface="Arial Unicode MS" pitchFamily="50" charset="-128"/>
                    <a:cs typeface="Arial Unicode MS" pitchFamily="50" charset="-128"/>
                  </a:rPr>
                  <a:t>*</a:t>
                </a:r>
              </a:p>
            </p:txBody>
          </p:sp>
          <p:cxnSp>
            <p:nvCxnSpPr>
              <p:cNvPr id="123" name="直線コネクタ 122"/>
              <p:cNvCxnSpPr/>
              <p:nvPr/>
            </p:nvCxnSpPr>
            <p:spPr>
              <a:xfrm>
                <a:off x="413609" y="5535078"/>
                <a:ext cx="9967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4" name="正方形/長方形 123"/>
          <p:cNvSpPr/>
          <p:nvPr/>
        </p:nvSpPr>
        <p:spPr>
          <a:xfrm>
            <a:off x="2028363" y="5941118"/>
            <a:ext cx="927546" cy="2354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</a:rPr>
              <a:t>DAD</a:t>
            </a:r>
            <a:endParaRPr kumimoji="1" lang="ja-JP" altLang="en-US" sz="1200" dirty="0">
              <a:solidFill>
                <a:schemeClr val="tx1"/>
              </a:solidFill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F8B8D9D3-5A87-469E-8599-A434853C76A1}"/>
              </a:ext>
            </a:extLst>
          </p:cNvPr>
          <p:cNvSpPr/>
          <p:nvPr/>
        </p:nvSpPr>
        <p:spPr>
          <a:xfrm>
            <a:off x="4539754" y="5941118"/>
            <a:ext cx="927546" cy="2354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</a:rPr>
              <a:t>DAD</a:t>
            </a:r>
            <a:endParaRPr kumimoji="1" lang="ja-JP" altLang="en-US" sz="1200" dirty="0">
              <a:solidFill>
                <a:schemeClr val="tx1"/>
              </a:solidFill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E6195041-428A-4FA5-B8D0-206BB935F835}"/>
              </a:ext>
            </a:extLst>
          </p:cNvPr>
          <p:cNvSpPr/>
          <p:nvPr/>
        </p:nvSpPr>
        <p:spPr>
          <a:xfrm>
            <a:off x="2040288" y="4433644"/>
            <a:ext cx="927546" cy="2354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</a:rPr>
              <a:t>DAD</a:t>
            </a:r>
            <a:endParaRPr kumimoji="1" lang="ja-JP" altLang="en-US" sz="1200" dirty="0">
              <a:solidFill>
                <a:schemeClr val="tx1"/>
              </a:solidFill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30CA345F-D36D-403B-94AD-E08C88548AD9}"/>
              </a:ext>
            </a:extLst>
          </p:cNvPr>
          <p:cNvSpPr/>
          <p:nvPr/>
        </p:nvSpPr>
        <p:spPr>
          <a:xfrm>
            <a:off x="4551679" y="4433644"/>
            <a:ext cx="927546" cy="2354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</a:rPr>
              <a:t>DAD</a:t>
            </a:r>
            <a:endParaRPr kumimoji="1" lang="ja-JP" altLang="en-US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701916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5474628"/>
              </p:ext>
            </p:extLst>
          </p:nvPr>
        </p:nvGraphicFramePr>
        <p:xfrm>
          <a:off x="1025050" y="374323"/>
          <a:ext cx="4857573" cy="7709845"/>
        </p:xfrm>
        <a:graphic>
          <a:graphicData uri="http://schemas.openxmlformats.org/drawingml/2006/table">
            <a:tbl>
              <a:tblPr/>
              <a:tblGrid>
                <a:gridCol w="2849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1994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89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4791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994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389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4791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1994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3898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.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phenotype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enotype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.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phenotype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enotype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.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phenotype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enotype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5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9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6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0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7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1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8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12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</a:tbl>
          </a:graphicData>
        </a:graphic>
      </p:graphicFrame>
      <p:sp>
        <p:nvSpPr>
          <p:cNvPr id="6" name="Rectangle 4">
            <a:extLst>
              <a:ext uri="{FF2B5EF4-FFF2-40B4-BE49-F238E27FC236}">
                <a16:creationId xmlns:a16="http://schemas.microsoft.com/office/drawing/2014/main" id="{2AF02ECE-3971-4C8D-AC84-9CE365785C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083" y="8141803"/>
            <a:ext cx="682590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3.</a:t>
            </a:r>
            <a:r>
              <a:rPr kumimoji="0" lang="en-US" altLang="ja-JP" sz="1200" b="0" i="0" u="none" strike="noStrike" cap="none" normalizeH="0" baseline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Relationship between phenotype and genotype in the F</a:t>
            </a:r>
            <a:r>
              <a:rPr kumimoji="0" lang="en-US" altLang="ja-JP" sz="1200" b="0" i="0" u="none" strike="noStrike" cap="none" normalizeH="0" baseline="-3000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kumimoji="0" lang="en-US" altLang="ja-JP" sz="1200" b="0" i="0" u="none" strike="noStrike" cap="none" normalizeH="0" baseline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population of </a:t>
            </a:r>
            <a:r>
              <a:rPr kumimoji="0" lang="en-US" altLang="ja-JP" sz="1200" b="0" i="1" u="none" strike="noStrike" cap="none" normalizeH="0" baseline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els1-1</a:t>
            </a:r>
            <a:r>
              <a:rPr kumimoji="0" lang="en-US" altLang="ja-JP" sz="1200" b="0" i="0" u="none" strike="noStrike" cap="none" normalizeH="0" baseline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x WT.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9983883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8954565"/>
              </p:ext>
            </p:extLst>
          </p:nvPr>
        </p:nvGraphicFramePr>
        <p:xfrm>
          <a:off x="2625270" y="195596"/>
          <a:ext cx="1637540" cy="7709845"/>
        </p:xfrm>
        <a:graphic>
          <a:graphicData uri="http://schemas.openxmlformats.org/drawingml/2006/table">
            <a:tbl>
              <a:tblPr/>
              <a:tblGrid>
                <a:gridCol w="27861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1994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89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phenotype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genotype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0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hetero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1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Normal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W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2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1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2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3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4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5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6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7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8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39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4152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040</a:t>
                      </a:r>
                    </a:p>
                  </a:txBody>
                  <a:tcPr marL="5165" marR="5165" marT="516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els1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mutant</a:t>
                      </a:r>
                    </a:p>
                  </a:txBody>
                  <a:tcPr marL="5165" marR="5165" marT="516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</a:tbl>
          </a:graphicData>
        </a:graphic>
      </p:graphicFrame>
      <p:sp>
        <p:nvSpPr>
          <p:cNvPr id="6" name="Rectangle 4">
            <a:extLst>
              <a:ext uri="{FF2B5EF4-FFF2-40B4-BE49-F238E27FC236}">
                <a16:creationId xmlns:a16="http://schemas.microsoft.com/office/drawing/2014/main" id="{DF07A97F-7D1B-4AF1-93FF-E214190B95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083" y="8141803"/>
            <a:ext cx="691247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4.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Relationship between phenotype and genotype in the F</a:t>
            </a:r>
            <a:r>
              <a:rPr kumimoji="0" lang="en-US" altLang="ja-JP" sz="1200" b="0" i="0" u="none" strike="noStrike" cap="none" normalizeH="0" baseline="-30000" dirty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population of </a:t>
            </a:r>
            <a:r>
              <a:rPr kumimoji="0" lang="en-US" altLang="ja-JP" sz="1200" b="0" i="1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els1-2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x WT.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7418942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正方形/長方形 51"/>
          <p:cNvSpPr/>
          <p:nvPr/>
        </p:nvSpPr>
        <p:spPr>
          <a:xfrm>
            <a:off x="698243" y="3760770"/>
            <a:ext cx="559030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5.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Expression levels of LHC and PSI core protein genes in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els1-2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. Real-time PCR was performed to examine the expression levels of the chloroplast protein genes. Total RNA from pre-senescent leaves (upper 4th leaves) of WT and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els1-2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 was used for </a:t>
            </a:r>
            <a:r>
              <a:rPr lang="en-US" altLang="ja-JP" sz="1200" dirty="0" err="1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qRT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-PCR. Expression levels were standardized using actin. Black bars indicate WT and white bars indicate </a:t>
            </a:r>
            <a:r>
              <a:rPr lang="en-US" altLang="ja-JP" sz="1200" i="1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els1-2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. Error bars indicate standard error (SE) (n=5 </a:t>
            </a:r>
            <a:r>
              <a:rPr lang="en-US" altLang="ja-JP" sz="1200" dirty="0"/>
              <a:t>biological replicates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). *P &lt; 0.05, </a:t>
            </a:r>
            <a:r>
              <a:rPr lang="en-US" altLang="ja-JP" sz="1200" dirty="0" err="1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n.s</a:t>
            </a:r>
            <a:r>
              <a:rPr lang="en-US" altLang="ja-JP" sz="12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., not significant (Student's t-test).</a:t>
            </a:r>
            <a:endParaRPr lang="ja-JP" altLang="ja-JP" sz="1200" dirty="0">
              <a:effectLst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0EC15EA6-3975-40C4-9AFA-B959DBE2706E}"/>
              </a:ext>
            </a:extLst>
          </p:cNvPr>
          <p:cNvGrpSpPr/>
          <p:nvPr/>
        </p:nvGrpSpPr>
        <p:grpSpPr>
          <a:xfrm>
            <a:off x="1335942" y="239126"/>
            <a:ext cx="4107093" cy="3278573"/>
            <a:chOff x="142142" y="239126"/>
            <a:chExt cx="4107093" cy="3278573"/>
          </a:xfrm>
        </p:grpSpPr>
        <p:graphicFrame>
          <p:nvGraphicFramePr>
            <p:cNvPr id="4" name="グラフ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66788319"/>
                </p:ext>
              </p:extLst>
            </p:nvPr>
          </p:nvGraphicFramePr>
          <p:xfrm>
            <a:off x="411675" y="239126"/>
            <a:ext cx="1939112" cy="9846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グラフ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33208284"/>
                </p:ext>
              </p:extLst>
            </p:nvPr>
          </p:nvGraphicFramePr>
          <p:xfrm>
            <a:off x="2310123" y="239126"/>
            <a:ext cx="1939112" cy="9846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グラフ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15971903"/>
                </p:ext>
              </p:extLst>
            </p:nvPr>
          </p:nvGraphicFramePr>
          <p:xfrm>
            <a:off x="2310123" y="1298415"/>
            <a:ext cx="1939112" cy="9846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0" name="グラフ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63488519"/>
                </p:ext>
              </p:extLst>
            </p:nvPr>
          </p:nvGraphicFramePr>
          <p:xfrm>
            <a:off x="411673" y="1298415"/>
            <a:ext cx="1939112" cy="9846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1" name="グラフ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73442694"/>
                </p:ext>
              </p:extLst>
            </p:nvPr>
          </p:nvGraphicFramePr>
          <p:xfrm>
            <a:off x="411673" y="2357702"/>
            <a:ext cx="1939112" cy="9846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2" name="正方形/長方形 11"/>
            <p:cNvSpPr/>
            <p:nvPr/>
          </p:nvSpPr>
          <p:spPr>
            <a:xfrm>
              <a:off x="670462" y="386589"/>
              <a:ext cx="969818" cy="24291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100" i="1" dirty="0">
                  <a:solidFill>
                    <a:schemeClr val="tx1"/>
                  </a:solidFill>
                </a:rPr>
                <a:t>GmLhca1</a:t>
              </a:r>
              <a:endParaRPr kumimoji="1" lang="ja-JP" altLang="en-US" sz="1100" i="1" dirty="0">
                <a:solidFill>
                  <a:schemeClr val="tx1"/>
                </a:solidFill>
              </a:endParaRPr>
            </a:p>
          </p:txBody>
        </p:sp>
        <p:sp>
          <p:nvSpPr>
            <p:cNvPr id="13" name="正方形/長方形 12"/>
            <p:cNvSpPr/>
            <p:nvPr/>
          </p:nvSpPr>
          <p:spPr>
            <a:xfrm>
              <a:off x="2611745" y="386589"/>
              <a:ext cx="881653" cy="24291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100" i="1" dirty="0">
                  <a:solidFill>
                    <a:schemeClr val="tx1"/>
                  </a:solidFill>
                </a:rPr>
                <a:t>GmLhca2</a:t>
              </a:r>
              <a:endParaRPr kumimoji="1" lang="ja-JP" altLang="en-US" sz="1100" i="1" dirty="0">
                <a:solidFill>
                  <a:schemeClr val="tx1"/>
                </a:solidFill>
              </a:endParaRPr>
            </a:p>
          </p:txBody>
        </p:sp>
        <p:sp>
          <p:nvSpPr>
            <p:cNvPr id="14" name="正方形/長方形 13"/>
            <p:cNvSpPr/>
            <p:nvPr/>
          </p:nvSpPr>
          <p:spPr>
            <a:xfrm>
              <a:off x="670462" y="1442635"/>
              <a:ext cx="969818" cy="24291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100" i="1" dirty="0" err="1">
                  <a:solidFill>
                    <a:schemeClr val="tx1"/>
                  </a:solidFill>
                </a:rPr>
                <a:t>GmPsaL</a:t>
              </a:r>
              <a:endParaRPr kumimoji="1" lang="ja-JP" altLang="en-US" sz="1100" i="1" dirty="0">
                <a:solidFill>
                  <a:schemeClr val="tx1"/>
                </a:solidFill>
              </a:endParaRPr>
            </a:p>
          </p:txBody>
        </p:sp>
        <p:sp>
          <p:nvSpPr>
            <p:cNvPr id="15" name="正方形/長方形 14"/>
            <p:cNvSpPr/>
            <p:nvPr/>
          </p:nvSpPr>
          <p:spPr>
            <a:xfrm>
              <a:off x="2611745" y="1455335"/>
              <a:ext cx="881653" cy="24291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100" i="1" dirty="0" err="1">
                  <a:solidFill>
                    <a:schemeClr val="tx1"/>
                  </a:solidFill>
                </a:rPr>
                <a:t>GmPsaH</a:t>
              </a:r>
              <a:endParaRPr kumimoji="1" lang="ja-JP" altLang="en-US" sz="1100" i="1" dirty="0">
                <a:solidFill>
                  <a:schemeClr val="tx1"/>
                </a:solidFill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670462" y="2503154"/>
              <a:ext cx="969818" cy="24291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100" i="1" dirty="0">
                  <a:solidFill>
                    <a:schemeClr val="tx1"/>
                  </a:solidFill>
                </a:rPr>
                <a:t>GmLhcb1</a:t>
              </a:r>
              <a:endParaRPr kumimoji="1" lang="ja-JP" altLang="en-US" sz="1100" i="1" dirty="0">
                <a:solidFill>
                  <a:schemeClr val="tx1"/>
                </a:solidFill>
              </a:endParaRPr>
            </a:p>
          </p:txBody>
        </p:sp>
        <p:sp>
          <p:nvSpPr>
            <p:cNvPr id="20" name="正方形/長方形 19"/>
            <p:cNvSpPr/>
            <p:nvPr/>
          </p:nvSpPr>
          <p:spPr>
            <a:xfrm>
              <a:off x="1598501" y="328325"/>
              <a:ext cx="497670" cy="182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 err="1">
                  <a:solidFill>
                    <a:schemeClr val="tx1"/>
                  </a:solidFill>
                </a:rPr>
                <a:t>n</a:t>
              </a:r>
              <a:r>
                <a:rPr kumimoji="1" lang="en-US" altLang="ja-JP" sz="1000" dirty="0" err="1">
                  <a:solidFill>
                    <a:schemeClr val="tx1"/>
                  </a:solidFill>
                </a:rPr>
                <a:t>.s</a:t>
              </a:r>
              <a:r>
                <a:rPr kumimoji="1" lang="en-US" altLang="ja-JP" sz="1000" dirty="0">
                  <a:solidFill>
                    <a:schemeClr val="tx1"/>
                  </a:solidFill>
                </a:rPr>
                <a:t>.</a:t>
              </a:r>
              <a:endParaRPr kumimoji="1" lang="ja-JP" altLang="en-US" sz="1000" dirty="0">
                <a:solidFill>
                  <a:schemeClr val="tx1"/>
                </a:solidFill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3502673" y="347375"/>
              <a:ext cx="497670" cy="182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 err="1">
                  <a:solidFill>
                    <a:schemeClr val="tx1"/>
                  </a:solidFill>
                </a:rPr>
                <a:t>n</a:t>
              </a:r>
              <a:r>
                <a:rPr kumimoji="1" lang="en-US" altLang="ja-JP" sz="1000" dirty="0" err="1">
                  <a:solidFill>
                    <a:schemeClr val="tx1"/>
                  </a:solidFill>
                </a:rPr>
                <a:t>.s</a:t>
              </a:r>
              <a:r>
                <a:rPr kumimoji="1" lang="en-US" altLang="ja-JP" sz="1000" dirty="0">
                  <a:solidFill>
                    <a:schemeClr val="tx1"/>
                  </a:solidFill>
                </a:rPr>
                <a:t>.</a:t>
              </a:r>
              <a:endParaRPr kumimoji="1" lang="ja-JP" altLang="en-US" sz="1000" dirty="0">
                <a:solidFill>
                  <a:schemeClr val="tx1"/>
                </a:solidFill>
              </a:endParaRPr>
            </a:p>
          </p:txBody>
        </p:sp>
        <p:sp>
          <p:nvSpPr>
            <p:cNvPr id="22" name="正方形/長方形 21"/>
            <p:cNvSpPr/>
            <p:nvPr/>
          </p:nvSpPr>
          <p:spPr>
            <a:xfrm>
              <a:off x="1598502" y="1392896"/>
              <a:ext cx="497670" cy="182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 err="1">
                  <a:solidFill>
                    <a:schemeClr val="tx1"/>
                  </a:solidFill>
                </a:rPr>
                <a:t>n</a:t>
              </a:r>
              <a:r>
                <a:rPr kumimoji="1" lang="en-US" altLang="ja-JP" sz="1000" dirty="0" err="1">
                  <a:solidFill>
                    <a:schemeClr val="tx1"/>
                  </a:solidFill>
                </a:rPr>
                <a:t>.s</a:t>
              </a:r>
              <a:r>
                <a:rPr kumimoji="1" lang="en-US" altLang="ja-JP" sz="1000" dirty="0">
                  <a:solidFill>
                    <a:schemeClr val="tx1"/>
                  </a:solidFill>
                </a:rPr>
                <a:t>.</a:t>
              </a:r>
              <a:endParaRPr kumimoji="1" lang="ja-JP" altLang="en-US" sz="1000" dirty="0">
                <a:solidFill>
                  <a:schemeClr val="tx1"/>
                </a:solidFill>
              </a:endParaRPr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3502676" y="1411946"/>
              <a:ext cx="497670" cy="182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 err="1">
                  <a:solidFill>
                    <a:schemeClr val="tx1"/>
                  </a:solidFill>
                </a:rPr>
                <a:t>n</a:t>
              </a:r>
              <a:r>
                <a:rPr kumimoji="1" lang="en-US" altLang="ja-JP" sz="1000" dirty="0" err="1">
                  <a:solidFill>
                    <a:schemeClr val="tx1"/>
                  </a:solidFill>
                </a:rPr>
                <a:t>.s</a:t>
              </a:r>
              <a:r>
                <a:rPr kumimoji="1" lang="en-US" altLang="ja-JP" sz="1000" dirty="0">
                  <a:solidFill>
                    <a:schemeClr val="tx1"/>
                  </a:solidFill>
                </a:rPr>
                <a:t>.</a:t>
              </a:r>
              <a:endParaRPr kumimoji="1" lang="ja-JP" altLang="en-US" sz="1000" dirty="0">
                <a:solidFill>
                  <a:schemeClr val="tx1"/>
                </a:solidFill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1598500" y="2444990"/>
              <a:ext cx="497670" cy="182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 err="1">
                  <a:solidFill>
                    <a:schemeClr val="tx1"/>
                  </a:solidFill>
                </a:rPr>
                <a:t>n</a:t>
              </a:r>
              <a:r>
                <a:rPr kumimoji="1" lang="en-US" altLang="ja-JP" sz="1000" dirty="0" err="1">
                  <a:solidFill>
                    <a:schemeClr val="tx1"/>
                  </a:solidFill>
                </a:rPr>
                <a:t>.s</a:t>
              </a:r>
              <a:r>
                <a:rPr kumimoji="1" lang="en-US" altLang="ja-JP" sz="1000" dirty="0">
                  <a:solidFill>
                    <a:schemeClr val="tx1"/>
                  </a:solidFill>
                </a:rPr>
                <a:t>.</a:t>
              </a:r>
              <a:endParaRPr kumimoji="1" lang="ja-JP" altLang="en-US" sz="1000" dirty="0">
                <a:solidFill>
                  <a:schemeClr val="tx1"/>
                </a:solidFill>
              </a:endParaRPr>
            </a:p>
          </p:txBody>
        </p:sp>
        <p:graphicFrame>
          <p:nvGraphicFramePr>
            <p:cNvPr id="28" name="グラフ 2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0597963"/>
                </p:ext>
              </p:extLst>
            </p:nvPr>
          </p:nvGraphicFramePr>
          <p:xfrm>
            <a:off x="2308173" y="2334692"/>
            <a:ext cx="1939112" cy="10076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35" name="正方形/長方形 34"/>
            <p:cNvSpPr/>
            <p:nvPr/>
          </p:nvSpPr>
          <p:spPr>
            <a:xfrm>
              <a:off x="2592501" y="2483469"/>
              <a:ext cx="801503" cy="24291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100" i="1" dirty="0">
                  <a:solidFill>
                    <a:schemeClr val="tx1"/>
                  </a:solidFill>
                </a:rPr>
                <a:t>GmLhcb2</a:t>
              </a:r>
              <a:endParaRPr kumimoji="1" lang="ja-JP" altLang="en-US" sz="1100" i="1" dirty="0">
                <a:solidFill>
                  <a:schemeClr val="tx1"/>
                </a:solidFill>
              </a:endParaRPr>
            </a:p>
          </p:txBody>
        </p:sp>
        <p:sp>
          <p:nvSpPr>
            <p:cNvPr id="36" name="正方形/長方形 35"/>
            <p:cNvSpPr/>
            <p:nvPr/>
          </p:nvSpPr>
          <p:spPr>
            <a:xfrm>
              <a:off x="3506231" y="2419066"/>
              <a:ext cx="497670" cy="182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sz="1000" dirty="0" err="1">
                  <a:solidFill>
                    <a:schemeClr val="tx1"/>
                  </a:solidFill>
                </a:rPr>
                <a:t>n</a:t>
              </a:r>
              <a:r>
                <a:rPr kumimoji="1" lang="en-US" altLang="ja-JP" sz="1000" dirty="0" err="1">
                  <a:solidFill>
                    <a:schemeClr val="tx1"/>
                  </a:solidFill>
                </a:rPr>
                <a:t>.s</a:t>
              </a:r>
              <a:r>
                <a:rPr kumimoji="1" lang="en-US" altLang="ja-JP" sz="1000" dirty="0">
                  <a:solidFill>
                    <a:schemeClr val="tx1"/>
                  </a:solidFill>
                </a:rPr>
                <a:t>.</a:t>
              </a:r>
              <a:endParaRPr kumimoji="1" lang="ja-JP" altLang="en-US" sz="1000" dirty="0">
                <a:solidFill>
                  <a:schemeClr val="tx1"/>
                </a:solidFill>
              </a:endParaRPr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8D23FA36-FB0A-4DF4-B4C2-710066A5E6F8}"/>
                </a:ext>
              </a:extLst>
            </p:cNvPr>
            <p:cNvSpPr/>
            <p:nvPr/>
          </p:nvSpPr>
          <p:spPr>
            <a:xfrm>
              <a:off x="868989" y="3203986"/>
              <a:ext cx="503802" cy="3056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200" dirty="0">
                  <a:solidFill>
                    <a:schemeClr val="tx1"/>
                  </a:solidFill>
                </a:rPr>
                <a:t>WT</a:t>
              </a:r>
              <a:endParaRPr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D0C6D821-E402-4377-A700-AA6C8B7C754C}"/>
                </a:ext>
              </a:extLst>
            </p:cNvPr>
            <p:cNvSpPr/>
            <p:nvPr/>
          </p:nvSpPr>
          <p:spPr>
            <a:xfrm>
              <a:off x="1489651" y="3197426"/>
              <a:ext cx="738646" cy="30569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200" i="1" dirty="0">
                  <a:solidFill>
                    <a:schemeClr val="tx1"/>
                  </a:solidFill>
                </a:rPr>
                <a:t>els1-2</a:t>
              </a:r>
              <a:endParaRPr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803B1CC8-C5FF-474F-93A0-7D5D55914485}"/>
                </a:ext>
              </a:extLst>
            </p:cNvPr>
            <p:cNvSpPr/>
            <p:nvPr/>
          </p:nvSpPr>
          <p:spPr>
            <a:xfrm>
              <a:off x="2773191" y="3212007"/>
              <a:ext cx="503802" cy="3056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200" dirty="0">
                  <a:solidFill>
                    <a:schemeClr val="tx1"/>
                  </a:solidFill>
                </a:rPr>
                <a:t>WT</a:t>
              </a:r>
              <a:endParaRPr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EC31A02B-F933-4119-8182-1F65918EB10E}"/>
                </a:ext>
              </a:extLst>
            </p:cNvPr>
            <p:cNvSpPr/>
            <p:nvPr/>
          </p:nvSpPr>
          <p:spPr>
            <a:xfrm>
              <a:off x="3393853" y="3205447"/>
              <a:ext cx="738646" cy="30569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ja-JP" sz="1200" i="1" dirty="0">
                  <a:solidFill>
                    <a:schemeClr val="tx1"/>
                  </a:solidFill>
                </a:rPr>
                <a:t>els1-2</a:t>
              </a:r>
              <a:endParaRPr lang="ja-JP" altLang="en-US" sz="1200" i="1" dirty="0">
                <a:solidFill>
                  <a:schemeClr val="tx1"/>
                </a:solidFill>
              </a:endParaRPr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912A242B-4525-4D8B-91FB-FD635BFEAA7E}"/>
                </a:ext>
              </a:extLst>
            </p:cNvPr>
            <p:cNvSpPr/>
            <p:nvPr/>
          </p:nvSpPr>
          <p:spPr>
            <a:xfrm rot="16200000">
              <a:off x="-489162" y="1686514"/>
              <a:ext cx="1455107" cy="1924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200" dirty="0">
                  <a:solidFill>
                    <a:schemeClr val="tx1"/>
                  </a:solidFill>
                </a:rPr>
                <a:t>Relative expression </a:t>
              </a:r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499310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E3F9C55F-6770-4BF0-B726-A7CDA6A653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0103738"/>
              </p:ext>
            </p:extLst>
          </p:nvPr>
        </p:nvGraphicFramePr>
        <p:xfrm>
          <a:off x="595175" y="3848723"/>
          <a:ext cx="5467884" cy="42596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46246">
                  <a:extLst>
                    <a:ext uri="{9D8B030D-6E8A-4147-A177-3AD203B41FA5}">
                      <a16:colId xmlns:a16="http://schemas.microsoft.com/office/drawing/2014/main" val="2309746851"/>
                    </a:ext>
                  </a:extLst>
                </a:gridCol>
                <a:gridCol w="1954346">
                  <a:extLst>
                    <a:ext uri="{9D8B030D-6E8A-4147-A177-3AD203B41FA5}">
                      <a16:colId xmlns:a16="http://schemas.microsoft.com/office/drawing/2014/main" val="709319785"/>
                    </a:ext>
                  </a:extLst>
                </a:gridCol>
                <a:gridCol w="1932121">
                  <a:extLst>
                    <a:ext uri="{9D8B030D-6E8A-4147-A177-3AD203B41FA5}">
                      <a16:colId xmlns:a16="http://schemas.microsoft.com/office/drawing/2014/main" val="4040000492"/>
                    </a:ext>
                  </a:extLst>
                </a:gridCol>
                <a:gridCol w="935171">
                  <a:extLst>
                    <a:ext uri="{9D8B030D-6E8A-4147-A177-3AD203B41FA5}">
                      <a16:colId xmlns:a16="http://schemas.microsoft.com/office/drawing/2014/main" val="1952482266"/>
                    </a:ext>
                  </a:extLst>
                </a:gridCol>
              </a:tblGrid>
              <a:tr h="1110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Na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Forward prim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Reverse prim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Restriction enzy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2177278"/>
                  </a:ext>
                </a:extLst>
              </a:tr>
              <a:tr h="1110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els1-1 </a:t>
                      </a:r>
                      <a:r>
                        <a:rPr lang="en-US" sz="900" u="none" strike="noStrike" dirty="0" err="1">
                          <a:effectLst/>
                        </a:rPr>
                        <a:t>dCAP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ATCGCCCCATGCCCGTGC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CAGCCCTGTAAAAGAGTTCCTCTCCAACC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i="1" u="none" strike="noStrike" dirty="0" err="1">
                          <a:effectLst/>
                        </a:rPr>
                        <a:t>Msp</a:t>
                      </a:r>
                      <a:r>
                        <a:rPr lang="en-US" sz="900" u="none" strike="noStrike" dirty="0">
                          <a:effectLst/>
                        </a:rPr>
                        <a:t> 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2764739"/>
                  </a:ext>
                </a:extLst>
              </a:tr>
              <a:tr h="649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els1-2 </a:t>
                      </a:r>
                      <a:r>
                        <a:rPr lang="en-US" sz="900" u="none" strike="noStrike" dirty="0" err="1">
                          <a:effectLst/>
                        </a:rPr>
                        <a:t>dCAP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CCACTTCTGGAAGGACTGCTGGCAGTAT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ATCACAGTGGAGTATATTCC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i="1" u="none" strike="noStrike" dirty="0" err="1">
                          <a:effectLst/>
                        </a:rPr>
                        <a:t>BstZ</a:t>
                      </a:r>
                      <a:r>
                        <a:rPr lang="en-US" sz="900" u="none" strike="noStrike" dirty="0">
                          <a:effectLst/>
                        </a:rPr>
                        <a:t> 17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4829" marR="4829" marT="4829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3566307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8023DE64-AE96-4BA8-ACD9-2B1E25BDE8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3564772"/>
              </p:ext>
            </p:extLst>
          </p:nvPr>
        </p:nvGraphicFramePr>
        <p:xfrm>
          <a:off x="1209993" y="5147025"/>
          <a:ext cx="4438014" cy="21850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2722">
                  <a:extLst>
                    <a:ext uri="{9D8B030D-6E8A-4147-A177-3AD203B41FA5}">
                      <a16:colId xmlns:a16="http://schemas.microsoft.com/office/drawing/2014/main" val="2167193502"/>
                    </a:ext>
                  </a:extLst>
                </a:gridCol>
                <a:gridCol w="1648697">
                  <a:extLst>
                    <a:ext uri="{9D8B030D-6E8A-4147-A177-3AD203B41FA5}">
                      <a16:colId xmlns:a16="http://schemas.microsoft.com/office/drawing/2014/main" val="392627962"/>
                    </a:ext>
                  </a:extLst>
                </a:gridCol>
                <a:gridCol w="1956595">
                  <a:extLst>
                    <a:ext uri="{9D8B030D-6E8A-4147-A177-3AD203B41FA5}">
                      <a16:colId xmlns:a16="http://schemas.microsoft.com/office/drawing/2014/main" val="4268205635"/>
                    </a:ext>
                  </a:extLst>
                </a:gridCol>
              </a:tblGrid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Na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Forward prim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Reverse prime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9481601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ELS1/GmBCM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ATGGAGAGACTCGGACT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TGGCACCATAAATCCCGAG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2637899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mBCM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ATGGGGAGGCTCGTAGCG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ATGGCACCATAAATCCCGA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208780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mLhca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TGAATTCCTTGCTATTTCCT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AGCAAGACGTCCATTCTTAA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07533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mLhca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ATCCAGCACTACAGTTTG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GATCAGATGCAAGACCTAG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4141415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Lhcb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TTGCCAAGAACCGTGAAC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TGAACCACACGGCTTCACC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7923597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Lhcb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</a:rPr>
                        <a:t>GCATTTGGTATGGCCCTGA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TGTCCCATCCGTAGTCACC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4946716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Psa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TGCTGTTCAACCAGCTACG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CACCACTCCTGAAGTTC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7739505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Ps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TCAAGTCCACCTTCACTAA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AATCACTTGATAGGTTGGCT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0057415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NY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ACACGAGAAGCTGTGCGT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TAGAACCATATACGGCAGT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4850006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SGR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CTTTCCACCGCTTACGTT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AGCATCCCCGTAACTGTG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0245504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NAC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ATATTCCTGAAACAGCTTG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TGCCCTTGCGGAGGATAG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1862610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SAG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ATGCATGAAATGGAGAACAA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CCAACTTCTATAGGTTCATTAT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5222365"/>
                  </a:ext>
                </a:extLst>
              </a:tr>
              <a:tr h="1560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Gm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TAAATCACGTTTAGTTCGCAC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GGCGTGGTCGCCCAATAAT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6786" marR="6786" marT="678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6137676"/>
                  </a:ext>
                </a:extLst>
              </a:tr>
            </a:tbl>
          </a:graphicData>
        </a:graphic>
      </p:graphicFrame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390F49A0-A3EE-4184-A705-EBFA309C72BD}"/>
              </a:ext>
            </a:extLst>
          </p:cNvPr>
          <p:cNvSpPr/>
          <p:nvPr/>
        </p:nvSpPr>
        <p:spPr>
          <a:xfrm>
            <a:off x="43749" y="7332090"/>
            <a:ext cx="676427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Supplemental Table 3. </a:t>
            </a:r>
            <a:r>
              <a:rPr lang="en-US" altLang="ja-JP" sz="1200" dirty="0"/>
              <a:t>Primer pairs for </a:t>
            </a:r>
            <a:r>
              <a:rPr lang="en-US" altLang="ja-JP" sz="1200" dirty="0" err="1"/>
              <a:t>qRT</a:t>
            </a:r>
            <a:r>
              <a:rPr lang="en-US" altLang="ja-JP" sz="1200" dirty="0"/>
              <a:t>-PCR</a:t>
            </a: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41F0AF13-554B-425B-8833-63C477C22550}"/>
              </a:ext>
            </a:extLst>
          </p:cNvPr>
          <p:cNvSpPr/>
          <p:nvPr/>
        </p:nvSpPr>
        <p:spPr>
          <a:xfrm>
            <a:off x="53189" y="4284489"/>
            <a:ext cx="676427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Supplemental Table</a:t>
            </a:r>
            <a:r>
              <a:rPr lang="ja-JP" altLang="en-US" sz="1200" b="1" dirty="0"/>
              <a:t> </a:t>
            </a:r>
            <a:r>
              <a:rPr lang="en-US" altLang="ja-JP" sz="1200" b="1" dirty="0"/>
              <a:t>2.</a:t>
            </a:r>
            <a:r>
              <a:rPr lang="en-US" altLang="ja-JP" sz="1200" dirty="0"/>
              <a:t> Primer pairs for </a:t>
            </a:r>
            <a:r>
              <a:rPr lang="en-US" altLang="ja-JP" sz="1200" dirty="0" err="1"/>
              <a:t>dCAPS</a:t>
            </a:r>
            <a:r>
              <a:rPr lang="en-US" altLang="ja-JP" sz="1200" dirty="0"/>
              <a:t> markers and restriction enzymes.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D90EA8A9-32A6-49E8-A98B-680A6635D1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0586930"/>
              </p:ext>
            </p:extLst>
          </p:nvPr>
        </p:nvGraphicFramePr>
        <p:xfrm>
          <a:off x="2154052" y="458516"/>
          <a:ext cx="2410143" cy="19964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1803">
                  <a:extLst>
                    <a:ext uri="{9D8B030D-6E8A-4147-A177-3AD203B41FA5}">
                      <a16:colId xmlns:a16="http://schemas.microsoft.com/office/drawing/2014/main" val="266581611"/>
                    </a:ext>
                  </a:extLst>
                </a:gridCol>
                <a:gridCol w="1958340">
                  <a:extLst>
                    <a:ext uri="{9D8B030D-6E8A-4147-A177-3AD203B41FA5}">
                      <a16:colId xmlns:a16="http://schemas.microsoft.com/office/drawing/2014/main" val="1313592847"/>
                    </a:ext>
                  </a:extLst>
                </a:gridCol>
              </a:tblGrid>
              <a:tr h="871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Nam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Prim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9400113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ELS1 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TTATCTCCACATGGCAGGCGGTGATT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9936408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ELS1 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CAGGCGGTGATTGGTCGT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573741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ELS1 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TGAGTTTCAACCGCGGAA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9888599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ELS1 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CATGAAGTAAAAGTGTCTGG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3395168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ELS1 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TCAACTTTTTGAAACCCCG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1611659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ELS1 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AGTTCAAACTTGTTCAGTG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3869705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ELS1 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CAAGTATAGGAAGCCAGAA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2745515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ELS1 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TACTCAGTAGGTTGTGTTG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4424327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ELS1 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GTTTGGAATGACTACGTGA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8987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ELS1 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ACCAAAATCAGTCGTGGA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1602216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ELS1 1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TGTTTAATGACTGGTTCAATTGTGG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08623"/>
                  </a:ext>
                </a:extLst>
              </a:tr>
            </a:tbl>
          </a:graphicData>
        </a:graphic>
      </p:graphicFrame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EAD23A76-B494-48CA-9843-1CD7307F9949}"/>
              </a:ext>
            </a:extLst>
          </p:cNvPr>
          <p:cNvSpPr/>
          <p:nvPr/>
        </p:nvSpPr>
        <p:spPr>
          <a:xfrm>
            <a:off x="36255" y="2453258"/>
            <a:ext cx="676427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Supplemental Table</a:t>
            </a:r>
            <a:r>
              <a:rPr lang="ja-JP" altLang="en-US" sz="1200" b="1" dirty="0"/>
              <a:t> </a:t>
            </a:r>
            <a:r>
              <a:rPr lang="en-US" altLang="ja-JP" sz="1200" b="1" dirty="0"/>
              <a:t>1. </a:t>
            </a:r>
            <a:r>
              <a:rPr lang="en-US" altLang="ja-JP" sz="1200" dirty="0"/>
              <a:t>Primers for Sanger sequencing.</a:t>
            </a:r>
          </a:p>
        </p:txBody>
      </p:sp>
    </p:spTree>
    <p:extLst>
      <p:ext uri="{BB962C8B-B14F-4D97-AF65-F5344CB8AC3E}">
        <p14:creationId xmlns:p14="http://schemas.microsoft.com/office/powerpoint/2010/main" val="2127710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/>
          <p:cNvSpPr/>
          <p:nvPr/>
        </p:nvSpPr>
        <p:spPr>
          <a:xfrm>
            <a:off x="0" y="2284655"/>
            <a:ext cx="676427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200" b="1" dirty="0"/>
              <a:t>Supplemental Table</a:t>
            </a:r>
            <a:r>
              <a:rPr lang="ja-JP" altLang="en-US" sz="1200" b="1" dirty="0"/>
              <a:t> </a:t>
            </a:r>
            <a:r>
              <a:rPr lang="en-US" altLang="ja-JP" sz="1200" b="1" dirty="0"/>
              <a:t>4. </a:t>
            </a:r>
            <a:r>
              <a:rPr lang="en-US" altLang="ja-JP" sz="1200" dirty="0"/>
              <a:t>SNPs of </a:t>
            </a:r>
            <a:r>
              <a:rPr lang="en-US" altLang="ja-JP" sz="1200" i="1" dirty="0"/>
              <a:t>els1-2</a:t>
            </a:r>
            <a:r>
              <a:rPr lang="en-US" altLang="ja-JP" sz="1200" dirty="0"/>
              <a:t> candidate genes by NGS-based bulked segregant analysis.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DFFB0E2C-FAFC-4D34-BF5E-F559FE994E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0602638"/>
              </p:ext>
            </p:extLst>
          </p:nvPr>
        </p:nvGraphicFramePr>
        <p:xfrm>
          <a:off x="457897" y="704850"/>
          <a:ext cx="5942206" cy="12813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3720">
                  <a:extLst>
                    <a:ext uri="{9D8B030D-6E8A-4147-A177-3AD203B41FA5}">
                      <a16:colId xmlns:a16="http://schemas.microsoft.com/office/drawing/2014/main" val="1058943558"/>
                    </a:ext>
                  </a:extLst>
                </a:gridCol>
                <a:gridCol w="1018207">
                  <a:extLst>
                    <a:ext uri="{9D8B030D-6E8A-4147-A177-3AD203B41FA5}">
                      <a16:colId xmlns:a16="http://schemas.microsoft.com/office/drawing/2014/main" val="2897717409"/>
                    </a:ext>
                  </a:extLst>
                </a:gridCol>
                <a:gridCol w="443532">
                  <a:extLst>
                    <a:ext uri="{9D8B030D-6E8A-4147-A177-3AD203B41FA5}">
                      <a16:colId xmlns:a16="http://schemas.microsoft.com/office/drawing/2014/main" val="2839517335"/>
                    </a:ext>
                  </a:extLst>
                </a:gridCol>
                <a:gridCol w="605457">
                  <a:extLst>
                    <a:ext uri="{9D8B030D-6E8A-4147-A177-3AD203B41FA5}">
                      <a16:colId xmlns:a16="http://schemas.microsoft.com/office/drawing/2014/main" val="837374744"/>
                    </a:ext>
                  </a:extLst>
                </a:gridCol>
                <a:gridCol w="737219">
                  <a:extLst>
                    <a:ext uri="{9D8B030D-6E8A-4147-A177-3AD203B41FA5}">
                      <a16:colId xmlns:a16="http://schemas.microsoft.com/office/drawing/2014/main" val="4158222702"/>
                    </a:ext>
                  </a:extLst>
                </a:gridCol>
                <a:gridCol w="637207">
                  <a:extLst>
                    <a:ext uri="{9D8B030D-6E8A-4147-A177-3AD203B41FA5}">
                      <a16:colId xmlns:a16="http://schemas.microsoft.com/office/drawing/2014/main" val="707418315"/>
                    </a:ext>
                  </a:extLst>
                </a:gridCol>
                <a:gridCol w="900732">
                  <a:extLst>
                    <a:ext uri="{9D8B030D-6E8A-4147-A177-3AD203B41FA5}">
                      <a16:colId xmlns:a16="http://schemas.microsoft.com/office/drawing/2014/main" val="4064681257"/>
                    </a:ext>
                  </a:extLst>
                </a:gridCol>
                <a:gridCol w="926132">
                  <a:extLst>
                    <a:ext uri="{9D8B030D-6E8A-4147-A177-3AD203B41FA5}">
                      <a16:colId xmlns:a16="http://schemas.microsoft.com/office/drawing/2014/main" val="2901287128"/>
                    </a:ext>
                  </a:extLst>
                </a:gridCol>
              </a:tblGrid>
              <a:tr h="26397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Chromoso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Position</a:t>
                      </a:r>
                      <a:br>
                        <a:rPr lang="en-US" sz="900" u="none" strike="noStrike" dirty="0">
                          <a:effectLst/>
                          <a:latin typeface="+mn-lt"/>
                        </a:rPr>
                      </a:br>
                      <a:r>
                        <a:rPr lang="en-US" sz="900" u="none" strike="noStrike" dirty="0">
                          <a:effectLst/>
                          <a:latin typeface="+mn-lt"/>
                        </a:rPr>
                        <a:t>(Gmax_275_v2.0 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Typ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Base </a:t>
                      </a:r>
                      <a:br>
                        <a:rPr lang="en-US" sz="900" u="none" strike="noStrike" dirty="0">
                          <a:effectLst/>
                          <a:latin typeface="+mn-lt"/>
                        </a:rPr>
                      </a:br>
                      <a:r>
                        <a:rPr lang="en-US" sz="900" u="none" strike="noStrike" dirty="0">
                          <a:effectLst/>
                          <a:latin typeface="+mn-lt"/>
                        </a:rPr>
                        <a:t>substitutio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Wild type bulk </a:t>
                      </a:r>
                      <a:br>
                        <a:rPr lang="en-US" sz="900" u="none" strike="noStrike" dirty="0">
                          <a:effectLst/>
                          <a:latin typeface="+mn-lt"/>
                        </a:rPr>
                      </a:br>
                      <a:r>
                        <a:rPr lang="en-US" sz="900" u="none" strike="noStrike" dirty="0">
                          <a:effectLst/>
                          <a:latin typeface="+mn-lt"/>
                        </a:rPr>
                        <a:t>frequenc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Mutant bulk </a:t>
                      </a:r>
                      <a:br>
                        <a:rPr lang="en-US" sz="900" u="none" strike="noStrike" dirty="0">
                          <a:effectLst/>
                          <a:latin typeface="+mn-lt"/>
                        </a:rPr>
                      </a:br>
                      <a:r>
                        <a:rPr lang="en-US" sz="900" u="none" strike="noStrike" dirty="0">
                          <a:effectLst/>
                          <a:latin typeface="+mn-lt"/>
                        </a:rPr>
                        <a:t>frequenc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Soybean ID</a:t>
                      </a:r>
                      <a:br>
                        <a:rPr lang="en-US" sz="900" u="none" strike="noStrike" dirty="0">
                          <a:effectLst/>
                          <a:latin typeface="+mn-lt"/>
                        </a:rPr>
                      </a:br>
                      <a:r>
                        <a:rPr lang="en-US" sz="900" u="none" strike="noStrike" dirty="0">
                          <a:effectLst/>
                          <a:latin typeface="+mn-lt"/>
                        </a:rPr>
                        <a:t>(Gmax_275_v2.0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Amino acid </a:t>
                      </a:r>
                    </a:p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ＭＳ Ｐゴシック" panose="020B0600070205080204" pitchFamily="50" charset="-128"/>
                        </a:rPr>
                        <a:t>substitution</a:t>
                      </a:r>
                    </a:p>
                  </a:txBody>
                  <a:tcPr marL="5866" marR="5866" marT="586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4338033"/>
                  </a:ext>
                </a:extLst>
              </a:tr>
              <a:tr h="948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Chr0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7186590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SN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C→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2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7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Glyma.03G0539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Arg89Leu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6955305"/>
                  </a:ext>
                </a:extLst>
              </a:tr>
              <a:tr h="1349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Chr0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718659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SN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C→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25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7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Glyma.03G0539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Arg88Ly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8499947"/>
                  </a:ext>
                </a:extLst>
              </a:tr>
              <a:tr h="1349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Chr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149035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SN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G→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9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87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Glyma.11G0209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Ser810As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2118837"/>
                  </a:ext>
                </a:extLst>
              </a:tr>
              <a:tr h="1349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Chr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2917416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SNV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C→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10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96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Glyma.11G0399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Pro4285Se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1209900"/>
                  </a:ext>
                </a:extLst>
              </a:tr>
              <a:tr h="1349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Chr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319543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SN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G→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14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100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Glyma.11G0434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Tyr349*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027482"/>
                  </a:ext>
                </a:extLst>
              </a:tr>
              <a:tr h="1349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Chr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39093562..3909356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Dele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CAA→de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17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8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Glyma.20G1520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Asn81de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6924995"/>
                  </a:ext>
                </a:extLst>
              </a:tr>
              <a:tr h="1349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scaffold_1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2659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SNV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+mn-lt"/>
                        </a:rPr>
                        <a:t>G→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>
                          <a:effectLst/>
                          <a:latin typeface="+mn-lt"/>
                        </a:rPr>
                        <a:t>20 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+mn-lt"/>
                        </a:rPr>
                        <a:t>80 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Glyma.U00230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Asn681Ly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50" charset="-128"/>
                      </a:endParaRPr>
                    </a:p>
                  </a:txBody>
                  <a:tcPr marL="5866" marR="5866" marT="5866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01969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15100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F79C87C0-93BF-4753-AEFB-694BF997BCBA}" vid="{453A5465-D03F-4C8F-8866-7D6ADA64EE1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プレゼンテーション1</Template>
  <TotalTime>6827</TotalTime>
  <Words>1214</Words>
  <Application>Microsoft Office PowerPoint</Application>
  <PresentationFormat>画面に合わせる (4:3)</PresentationFormat>
  <Paragraphs>696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2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谷 浩史</dc:creator>
  <cp:lastModifiedBy>加賀　秋人</cp:lastModifiedBy>
  <cp:revision>187</cp:revision>
  <dcterms:created xsi:type="dcterms:W3CDTF">2019-11-09T12:26:51Z</dcterms:created>
  <dcterms:modified xsi:type="dcterms:W3CDTF">2021-11-15T07:57:39Z</dcterms:modified>
</cp:coreProperties>
</file>